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73" r:id="rId2"/>
    <p:sldId id="281" r:id="rId3"/>
    <p:sldId id="280" r:id="rId4"/>
    <p:sldId id="258" r:id="rId5"/>
    <p:sldId id="279" r:id="rId6"/>
    <p:sldId id="275" r:id="rId7"/>
    <p:sldId id="256" r:id="rId8"/>
    <p:sldId id="257" r:id="rId9"/>
    <p:sldId id="276" r:id="rId10"/>
    <p:sldId id="277" r:id="rId11"/>
    <p:sldId id="278" r:id="rId12"/>
  </p:sldIdLst>
  <p:sldSz cx="12192000" cy="6858000"/>
  <p:notesSz cx="6858000" cy="9144000"/>
  <p:defaultTextStyle>
    <a:defPPr>
      <a:defRPr lang="en-SA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334FEDA2-7FBE-C867-7AEA-47213E7B7D6B}" name="Kinjal Patel" initials="KP" userId="S::kinjal.patel@jrfonline.com::8bf96f16-dfb1-4763-ac69-72b88fe61e33" providerId="AD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3049"/>
    <p:restoredTop sz="94674"/>
  </p:normalViewPr>
  <p:slideViewPr>
    <p:cSldViewPr snapToGrid="0">
      <p:cViewPr varScale="1">
        <p:scale>
          <a:sx n="106" d="100"/>
          <a:sy n="106" d="100"/>
        </p:scale>
        <p:origin x="200" y="46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microsoft.com/office/2018/10/relationships/authors" Target="authors.xml"/><Relationship Id="rId2" Type="http://schemas.openxmlformats.org/officeDocument/2006/relationships/slide" Target="slides/slide1.xml"/><Relationship Id="rId1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theme" Target="theme/theme1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5152DD8-CAEC-76CC-3E9F-B93B1AE8325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SA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10C1D043-6719-69F8-018A-8118CDC2260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S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51B9E21-86F2-FE86-9DB8-D9F2B5FD97A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C0D36C-FE4F-C544-865B-7B44885C946A}" type="datetimeFigureOut">
              <a:rPr lang="en-SA" smtClean="0"/>
              <a:t>28/09/2024 R</a:t>
            </a:fld>
            <a:endParaRPr lang="en-S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3780588-6DB7-17EF-3658-7A7F57A231E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002A8C0-3EDF-F2C2-517F-7B7C100E45F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8B97EC-405E-7F4C-847E-02605AAC9E7D}" type="slidenum">
              <a:rPr lang="en-SA" smtClean="0"/>
              <a:t>‹#›</a:t>
            </a:fld>
            <a:endParaRPr lang="en-SA"/>
          </a:p>
        </p:txBody>
      </p:sp>
    </p:spTree>
    <p:extLst>
      <p:ext uri="{BB962C8B-B14F-4D97-AF65-F5344CB8AC3E}">
        <p14:creationId xmlns:p14="http://schemas.microsoft.com/office/powerpoint/2010/main" val="83465041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FBA04E2-E161-D97D-CD79-43CE6F05F0B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SA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0EAE76E-98C9-A0C7-C4BB-3CCB35F629D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S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FD0300A-6596-B07B-FB50-12AEA068761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C0D36C-FE4F-C544-865B-7B44885C946A}" type="datetimeFigureOut">
              <a:rPr lang="en-SA" smtClean="0"/>
              <a:t>28/09/2024 R</a:t>
            </a:fld>
            <a:endParaRPr lang="en-S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6D14693-781D-DD22-BCF4-339304A2843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4D8CADF-AF31-D039-C28A-2384F0A26F1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8B97EC-405E-7F4C-847E-02605AAC9E7D}" type="slidenum">
              <a:rPr lang="en-SA" smtClean="0"/>
              <a:t>‹#›</a:t>
            </a:fld>
            <a:endParaRPr lang="en-SA"/>
          </a:p>
        </p:txBody>
      </p:sp>
    </p:spTree>
    <p:extLst>
      <p:ext uri="{BB962C8B-B14F-4D97-AF65-F5344CB8AC3E}">
        <p14:creationId xmlns:p14="http://schemas.microsoft.com/office/powerpoint/2010/main" val="218049093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45E4068B-387F-33C5-17C6-CE9F5AD9A9F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SA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88A3087-621A-58E4-88CE-0F840BEB418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S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7F84F2E-2849-DD6C-76D3-99F3E7DA72D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C0D36C-FE4F-C544-865B-7B44885C946A}" type="datetimeFigureOut">
              <a:rPr lang="en-SA" smtClean="0"/>
              <a:t>28/09/2024 R</a:t>
            </a:fld>
            <a:endParaRPr lang="en-S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5D61F87-0716-5865-D026-151591B3598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35FC2AC-B23C-4ECA-1849-DC7A1A1B433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8B97EC-405E-7F4C-847E-02605AAC9E7D}" type="slidenum">
              <a:rPr lang="en-SA" smtClean="0"/>
              <a:t>‹#›</a:t>
            </a:fld>
            <a:endParaRPr lang="en-SA"/>
          </a:p>
        </p:txBody>
      </p:sp>
    </p:spTree>
    <p:extLst>
      <p:ext uri="{BB962C8B-B14F-4D97-AF65-F5344CB8AC3E}">
        <p14:creationId xmlns:p14="http://schemas.microsoft.com/office/powerpoint/2010/main" val="303686863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71CDB66-E27A-9D74-9563-EC3EBCB68EC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SA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7BEBC97-2836-E02F-2F6B-BBD32185D67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S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ED94882-0C5C-222B-2107-11088BB1CB3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C0D36C-FE4F-C544-865B-7B44885C946A}" type="datetimeFigureOut">
              <a:rPr lang="en-SA" smtClean="0"/>
              <a:t>28/09/2024 R</a:t>
            </a:fld>
            <a:endParaRPr lang="en-S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A222879-4FA7-0FF7-3278-452064F33A0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CD2A6A7-9ED5-8098-C521-0FCD4BF6FAB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8B97EC-405E-7F4C-847E-02605AAC9E7D}" type="slidenum">
              <a:rPr lang="en-SA" smtClean="0"/>
              <a:t>‹#›</a:t>
            </a:fld>
            <a:endParaRPr lang="en-SA"/>
          </a:p>
        </p:txBody>
      </p:sp>
    </p:spTree>
    <p:extLst>
      <p:ext uri="{BB962C8B-B14F-4D97-AF65-F5344CB8AC3E}">
        <p14:creationId xmlns:p14="http://schemas.microsoft.com/office/powerpoint/2010/main" val="148784225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9C038A3-4F55-6C91-AEE2-14064FD12F0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SA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5FA15F2-19A8-31A4-9751-ED669FD60A4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8D5A480-0C30-BF34-EA91-A87EBB17BAB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C0D36C-FE4F-C544-865B-7B44885C946A}" type="datetimeFigureOut">
              <a:rPr lang="en-SA" smtClean="0"/>
              <a:t>28/09/2024 R</a:t>
            </a:fld>
            <a:endParaRPr lang="en-S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F9300D8-9241-7E1F-235A-E58A92C3895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E261823-7379-EDCE-6BA8-318CCA9C917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8B97EC-405E-7F4C-847E-02605AAC9E7D}" type="slidenum">
              <a:rPr lang="en-SA" smtClean="0"/>
              <a:t>‹#›</a:t>
            </a:fld>
            <a:endParaRPr lang="en-SA"/>
          </a:p>
        </p:txBody>
      </p:sp>
    </p:spTree>
    <p:extLst>
      <p:ext uri="{BB962C8B-B14F-4D97-AF65-F5344CB8AC3E}">
        <p14:creationId xmlns:p14="http://schemas.microsoft.com/office/powerpoint/2010/main" val="42330733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8897CFE-0223-091D-D1DF-B3E32472041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SA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44353DC-73F6-DDC2-6DB3-535E4D4021C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SA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1AD8A91-C269-9A6A-4259-36EFD8A9D0D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SA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43190C0-EAC8-4CAB-75D1-0EA139FBFDA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C0D36C-FE4F-C544-865B-7B44885C946A}" type="datetimeFigureOut">
              <a:rPr lang="en-SA" smtClean="0"/>
              <a:t>28/09/2024 R</a:t>
            </a:fld>
            <a:endParaRPr lang="en-SA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CD53E1B-EC39-D7A6-4C33-50673EA2F8A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A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364EB8C-60C6-08A2-32C6-0FA91CAA803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8B97EC-405E-7F4C-847E-02605AAC9E7D}" type="slidenum">
              <a:rPr lang="en-SA" smtClean="0"/>
              <a:t>‹#›</a:t>
            </a:fld>
            <a:endParaRPr lang="en-SA"/>
          </a:p>
        </p:txBody>
      </p:sp>
    </p:spTree>
    <p:extLst>
      <p:ext uri="{BB962C8B-B14F-4D97-AF65-F5344CB8AC3E}">
        <p14:creationId xmlns:p14="http://schemas.microsoft.com/office/powerpoint/2010/main" val="128207442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7A55025-2A6C-56B8-80B3-3FB42599F2A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SA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740217F-27E9-3F7A-F450-29A87F676EB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F8DAA28-A707-2449-0DD9-26A6EBC0226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SA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388A0624-3445-0234-3B9E-98163EC3E40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ED23FCC0-F7B6-2103-5D5C-36C6E567362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SA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27FF9971-1AB3-48DE-BAE1-41D7C7E402A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C0D36C-FE4F-C544-865B-7B44885C946A}" type="datetimeFigureOut">
              <a:rPr lang="en-SA" smtClean="0"/>
              <a:t>28/09/2024 R</a:t>
            </a:fld>
            <a:endParaRPr lang="en-SA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E2B36589-9CC8-3656-7393-D3615976C46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A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37BC36B2-CDB7-3928-81F6-D2513C12C60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8B97EC-405E-7F4C-847E-02605AAC9E7D}" type="slidenum">
              <a:rPr lang="en-SA" smtClean="0"/>
              <a:t>‹#›</a:t>
            </a:fld>
            <a:endParaRPr lang="en-SA"/>
          </a:p>
        </p:txBody>
      </p:sp>
    </p:spTree>
    <p:extLst>
      <p:ext uri="{BB962C8B-B14F-4D97-AF65-F5344CB8AC3E}">
        <p14:creationId xmlns:p14="http://schemas.microsoft.com/office/powerpoint/2010/main" val="176223516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BF7FEED-1076-DFBB-B5F1-D56D998BF0E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SA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489BCC6A-6417-78A6-B9D8-D8CDC4C0AEF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C0D36C-FE4F-C544-865B-7B44885C946A}" type="datetimeFigureOut">
              <a:rPr lang="en-SA" smtClean="0"/>
              <a:t>28/09/2024 R</a:t>
            </a:fld>
            <a:endParaRPr lang="en-SA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C2BA3751-70B4-89E6-1EFE-A7D3E79BCCE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A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8000DB49-EED0-BB42-8EC9-67BA566B5D6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8B97EC-405E-7F4C-847E-02605AAC9E7D}" type="slidenum">
              <a:rPr lang="en-SA" smtClean="0"/>
              <a:t>‹#›</a:t>
            </a:fld>
            <a:endParaRPr lang="en-SA"/>
          </a:p>
        </p:txBody>
      </p:sp>
    </p:spTree>
    <p:extLst>
      <p:ext uri="{BB962C8B-B14F-4D97-AF65-F5344CB8AC3E}">
        <p14:creationId xmlns:p14="http://schemas.microsoft.com/office/powerpoint/2010/main" val="300603562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94C82E9B-4ED2-4415-406B-96A1801D18A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C0D36C-FE4F-C544-865B-7B44885C946A}" type="datetimeFigureOut">
              <a:rPr lang="en-SA" smtClean="0"/>
              <a:t>28/09/2024 R</a:t>
            </a:fld>
            <a:endParaRPr lang="en-SA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8EDEF7CE-C46E-2F4C-BBE7-6DC509D22F5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A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0B78BD1A-3238-432C-FBA9-E9A06AF0F3F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8B97EC-405E-7F4C-847E-02605AAC9E7D}" type="slidenum">
              <a:rPr lang="en-SA" smtClean="0"/>
              <a:t>‹#›</a:t>
            </a:fld>
            <a:endParaRPr lang="en-SA"/>
          </a:p>
        </p:txBody>
      </p:sp>
    </p:spTree>
    <p:extLst>
      <p:ext uri="{BB962C8B-B14F-4D97-AF65-F5344CB8AC3E}">
        <p14:creationId xmlns:p14="http://schemas.microsoft.com/office/powerpoint/2010/main" val="87158815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6195550-74DE-2EB8-B61E-1587B079A60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SA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42C0BAB-E9C0-AB9D-3B73-9B8446B39AE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SA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31C1AFE-2070-6A0C-FF88-6910C3ED08E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6E12548-7BDF-5163-33B3-D796DC15666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C0D36C-FE4F-C544-865B-7B44885C946A}" type="datetimeFigureOut">
              <a:rPr lang="en-SA" smtClean="0"/>
              <a:t>28/09/2024 R</a:t>
            </a:fld>
            <a:endParaRPr lang="en-SA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45A8AA3-280A-83FA-B8BD-D6241B1346E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A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7B73A35-DAC5-150F-FE38-97D34C6C51D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8B97EC-405E-7F4C-847E-02605AAC9E7D}" type="slidenum">
              <a:rPr lang="en-SA" smtClean="0"/>
              <a:t>‹#›</a:t>
            </a:fld>
            <a:endParaRPr lang="en-SA"/>
          </a:p>
        </p:txBody>
      </p:sp>
    </p:spTree>
    <p:extLst>
      <p:ext uri="{BB962C8B-B14F-4D97-AF65-F5344CB8AC3E}">
        <p14:creationId xmlns:p14="http://schemas.microsoft.com/office/powerpoint/2010/main" val="271529741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152BB6B-0CC8-3560-00F7-05E9CF4156D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SA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C56423A7-3C0C-9AD9-012F-BDD169A25D6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SA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EEEBE19-654B-A598-66BE-A502946DDFC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656E529-BA70-8830-B646-F1CD96F6526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C0D36C-FE4F-C544-865B-7B44885C946A}" type="datetimeFigureOut">
              <a:rPr lang="en-SA" smtClean="0"/>
              <a:t>28/09/2024 R</a:t>
            </a:fld>
            <a:endParaRPr lang="en-SA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D0B5C08-543E-4C98-70A2-2E40F270A13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A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53CB161-1DC9-436F-DB25-33422B371EE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8B97EC-405E-7F4C-847E-02605AAC9E7D}" type="slidenum">
              <a:rPr lang="en-SA" smtClean="0"/>
              <a:t>‹#›</a:t>
            </a:fld>
            <a:endParaRPr lang="en-SA"/>
          </a:p>
        </p:txBody>
      </p:sp>
    </p:spTree>
    <p:extLst>
      <p:ext uri="{BB962C8B-B14F-4D97-AF65-F5344CB8AC3E}">
        <p14:creationId xmlns:p14="http://schemas.microsoft.com/office/powerpoint/2010/main" val="183109779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F1A9C1A4-6D5D-F796-5075-9880EB38DCC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SA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CCF67D5-DECF-3A59-97A9-7219170E95E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S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EAB0272-2CE4-71C2-3884-85B96F917EA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6C0D36C-FE4F-C544-865B-7B44885C946A}" type="datetimeFigureOut">
              <a:rPr lang="en-SA" smtClean="0"/>
              <a:t>28/09/2024 R</a:t>
            </a:fld>
            <a:endParaRPr lang="en-S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AEF7CF7-AA12-A523-A97D-6C8FE3952A5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S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A9B4399-A8CE-AFDE-E24E-8BFC4764BD4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E8B97EC-405E-7F4C-847E-02605AAC9E7D}" type="slidenum">
              <a:rPr lang="en-SA" smtClean="0"/>
              <a:t>‹#›</a:t>
            </a:fld>
            <a:endParaRPr lang="en-SA"/>
          </a:p>
        </p:txBody>
      </p:sp>
    </p:spTree>
    <p:extLst>
      <p:ext uri="{BB962C8B-B14F-4D97-AF65-F5344CB8AC3E}">
        <p14:creationId xmlns:p14="http://schemas.microsoft.com/office/powerpoint/2010/main" val="348950349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SA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hyperlink" Target="https://doi.org/10.1016/j.bmc.2011.10.057" TargetMode="External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2.jpeg"/><Relationship Id="rId4" Type="http://schemas.openxmlformats.org/officeDocument/2006/relationships/hyperlink" Target="https://doi.org/10.1093%2Fjxb%2Ferx438" TargetMode="Externa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1.xml"/></Relationships>
</file>

<file path=ppt/slides/_rels/slide1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hyperlink" Target="https://doi.org/10.1016/j.bmc.2011.10.057" TargetMode="External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4.jpe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emf"/><Relationship Id="rId2" Type="http://schemas.openxmlformats.org/officeDocument/2006/relationships/image" Target="../media/image5.emf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emf"/><Relationship Id="rId1" Type="http://schemas.openxmlformats.org/officeDocument/2006/relationships/slideLayout" Target="../slideLayouts/slideLayout1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1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1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A7CBE10D-EAFB-AE07-168B-5C931D4076F5}"/>
              </a:ext>
            </a:extLst>
          </p:cNvPr>
          <p:cNvSpPr txBox="1"/>
          <p:nvPr/>
        </p:nvSpPr>
        <p:spPr>
          <a:xfrm>
            <a:off x="502989" y="5880413"/>
            <a:ext cx="580319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SA" sz="14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1: </a:t>
            </a: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The characterization of MP3 by </a:t>
            </a:r>
            <a:r>
              <a:rPr lang="en-US" sz="14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H NMR . </a:t>
            </a:r>
            <a:endParaRPr lang="en-SA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FEB4C376-0406-B249-29F6-E994DB9BC19E}"/>
              </a:ext>
            </a:extLst>
          </p:cNvPr>
          <p:cNvSpPr txBox="1"/>
          <p:nvPr/>
        </p:nvSpPr>
        <p:spPr>
          <a:xfrm>
            <a:off x="3568241" y="118867"/>
            <a:ext cx="55335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MP3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2AF81DAA-987B-784B-2776-2D852AE9344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609050" y="838200"/>
            <a:ext cx="4438650" cy="2590800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A986064F-8EA8-9B0B-EB79-D422C89FA1FE}"/>
              </a:ext>
            </a:extLst>
          </p:cNvPr>
          <p:cNvSpPr txBox="1"/>
          <p:nvPr/>
        </p:nvSpPr>
        <p:spPr>
          <a:xfrm>
            <a:off x="7518288" y="4075331"/>
            <a:ext cx="4579514" cy="120032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b="1" baseline="30000" dirty="0"/>
              <a:t>1</a:t>
            </a:r>
            <a:r>
              <a:rPr lang="en-US" sz="1200" b="1" dirty="0"/>
              <a:t>H NMR (500MHz, CDCl</a:t>
            </a:r>
            <a:r>
              <a:rPr lang="en-US" sz="1200" b="1" baseline="-25000" dirty="0"/>
              <a:t>3</a:t>
            </a:r>
            <a:r>
              <a:rPr lang="en-US" sz="1200" b="1" dirty="0"/>
              <a:t>): d7.74 (1H, s), 7.34 (2H, d, J = 7.5 Hz), 7.30 (3H, m,), 6.85 (1H, s), 6.14 (1H, s), 3.76 (3H, s), 1.97 (3H, s); </a:t>
            </a:r>
            <a:r>
              <a:rPr lang="en-US" sz="1200" b="1" baseline="30000" dirty="0"/>
              <a:t>13</a:t>
            </a:r>
            <a:r>
              <a:rPr lang="en-US" sz="1200" b="1" dirty="0"/>
              <a:t>C NMR (125MHz, </a:t>
            </a:r>
            <a:r>
              <a:rPr lang="en-US" sz="1200" b="1" dirty="0" err="1"/>
              <a:t>CDCl</a:t>
            </a:r>
            <a:r>
              <a:rPr lang="en-US" sz="1200" b="1" dirty="0"/>
              <a:t>) </a:t>
            </a:r>
            <a:r>
              <a:rPr lang="el-GR" sz="1200" b="1" dirty="0"/>
              <a:t>δ</a:t>
            </a:r>
            <a:r>
              <a:rPr lang="en-US" sz="1200" b="1" dirty="0"/>
              <a:t>ppm170.41, 167.18, 152.61, 141.26, 135.33, 131.51, 129.97, 127.77, 127.52, 115.54, 100.40, 51.83, 10.55; IR (</a:t>
            </a:r>
            <a:r>
              <a:rPr lang="en-US" sz="1200" b="1" dirty="0" err="1"/>
              <a:t>nujolmull</a:t>
            </a:r>
            <a:r>
              <a:rPr lang="en-US" sz="1200" b="1" dirty="0"/>
              <a:t> method): </a:t>
            </a:r>
            <a:r>
              <a:rPr lang="el-GR" sz="1200" b="1" dirty="0"/>
              <a:t>ν</a:t>
            </a:r>
            <a:r>
              <a:rPr lang="en-US" sz="1200" b="1" baseline="-25000" dirty="0"/>
              <a:t>max</a:t>
            </a:r>
            <a:r>
              <a:rPr lang="en-US" sz="1200" b="1" dirty="0"/>
              <a:t>1790, 1770, 1670 cm</a:t>
            </a:r>
            <a:r>
              <a:rPr lang="en-US" sz="1200" b="1" baseline="30000" dirty="0"/>
              <a:t>-1</a:t>
            </a:r>
            <a:r>
              <a:rPr lang="en-US" sz="1200" b="1" dirty="0"/>
              <a:t>. HRMS-ESI: m/z [M-Na]</a:t>
            </a:r>
            <a:r>
              <a:rPr lang="en-US" sz="1200" b="1" baseline="30000" dirty="0"/>
              <a:t>-</a:t>
            </a:r>
            <a:r>
              <a:rPr lang="en-US" sz="1200" b="1" dirty="0" err="1"/>
              <a:t>Calcdfor</a:t>
            </a:r>
            <a:r>
              <a:rPr lang="en-US" sz="1200" b="1" dirty="0"/>
              <a:t> C</a:t>
            </a:r>
            <a:r>
              <a:rPr lang="en-US" sz="1200" b="1" baseline="-25000" dirty="0"/>
              <a:t>15</a:t>
            </a:r>
            <a:r>
              <a:rPr lang="en-US" sz="1200" b="1" dirty="0"/>
              <a:t>H</a:t>
            </a:r>
            <a:r>
              <a:rPr lang="en-US" sz="1200" b="1" baseline="-25000" dirty="0"/>
              <a:t>14</a:t>
            </a:r>
            <a:r>
              <a:rPr lang="en-US" sz="1200" b="1" dirty="0"/>
              <a:t>Na</a:t>
            </a:r>
            <a:r>
              <a:rPr lang="en-US" sz="1200" b="1" baseline="-25000" dirty="0"/>
              <a:t>1</a:t>
            </a:r>
            <a:r>
              <a:rPr lang="en-US" sz="1200" b="1" dirty="0"/>
              <a:t>O</a:t>
            </a:r>
            <a:r>
              <a:rPr lang="en-US" sz="1200" b="1" baseline="-25000" dirty="0"/>
              <a:t>5</a:t>
            </a:r>
            <a:r>
              <a:rPr lang="en-US" sz="1200" b="1" dirty="0"/>
              <a:t>:297.07389, found: 297.07252. Yield: 50%.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E25605AA-9DBC-4A7F-62FC-AA75EA06CB20}"/>
              </a:ext>
            </a:extLst>
          </p:cNvPr>
          <p:cNvSpPr txBox="1"/>
          <p:nvPr/>
        </p:nvSpPr>
        <p:spPr>
          <a:xfrm>
            <a:off x="7518288" y="3429000"/>
            <a:ext cx="2750240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SA" sz="1200" b="1" dirty="0"/>
              <a:t>NMR information of MP3 adapted from:</a:t>
            </a:r>
          </a:p>
          <a:p>
            <a:r>
              <a:rPr lang="en-SA" sz="1200" b="1" dirty="0"/>
              <a:t>Jamil et al., 2018</a:t>
            </a:r>
          </a:p>
          <a:p>
            <a:r>
              <a:rPr lang="en-SA" sz="1200" b="1" dirty="0">
                <a:solidFill>
                  <a:schemeClr val="accent5">
                    <a:lumMod val="75000"/>
                  </a:schemeClr>
                </a:solidFill>
              </a:rPr>
              <a:t>(</a:t>
            </a:r>
            <a:r>
              <a:rPr lang="en-US" sz="1200" b="1" i="0" u="none" strike="noStrike" dirty="0">
                <a:solidFill>
                  <a:schemeClr val="accent5">
                    <a:lumMod val="75000"/>
                  </a:schemeClr>
                </a:solidFill>
                <a:effectLst/>
                <a:hlinkClick r:id="rId3" tooltip="Persistent link using digital object identifier">
                  <a:extLst>
                    <a:ext uri="{A12FA001-AC4F-418D-AE19-62706E023703}">
                      <ahyp:hlinkClr xmlns:ahyp="http://schemas.microsoft.com/office/drawing/2018/hyperlinkcolor" val="tx"/>
                    </a:ext>
                  </a:extLst>
                </a:hlinkClick>
              </a:rPr>
              <a:t>https://</a:t>
            </a:r>
            <a:r>
              <a:rPr lang="en-US" sz="1200" b="0" i="0" dirty="0">
                <a:solidFill>
                  <a:schemeClr val="accent5">
                    <a:lumMod val="75000"/>
                  </a:schemeClr>
                </a:solidFill>
                <a:effectLst/>
                <a:latin typeface="Helvetica Neue" panose="02000503000000020004" pitchFamily="2" charset="0"/>
              </a:rPr>
              <a:t>doi:</a:t>
            </a:r>
            <a:r>
              <a:rPr lang="en-US" sz="1200" b="0" i="0" u="sng" dirty="0">
                <a:solidFill>
                  <a:schemeClr val="accent5">
                    <a:lumMod val="75000"/>
                  </a:schemeClr>
                </a:solidFill>
                <a:effectLst/>
                <a:latin typeface="Helvetica Neue" panose="02000503000000020004" pitchFamily="2" charset="0"/>
                <a:hlinkClick r:id="rId4">
                  <a:extLst>
                    <a:ext uri="{A12FA001-AC4F-418D-AE19-62706E023703}">
                      <ahyp:hlinkClr xmlns:ahyp="http://schemas.microsoft.com/office/drawing/2018/hyperlinkcolor" val="tx"/>
                    </a:ext>
                  </a:extLst>
                </a:hlinkClick>
              </a:rPr>
              <a:t>10.1093/jxb/erx438</a:t>
            </a:r>
            <a:r>
              <a:rPr lang="en-SA" sz="1200" b="1" i="0" u="none" strike="noStrike" dirty="0">
                <a:solidFill>
                  <a:schemeClr val="accent5">
                    <a:lumMod val="75000"/>
                  </a:schemeClr>
                </a:solidFill>
                <a:effectLst/>
              </a:rPr>
              <a:t>)</a:t>
            </a:r>
            <a:endParaRPr lang="en-SA" sz="1200" b="1" dirty="0">
              <a:solidFill>
                <a:schemeClr val="accent5">
                  <a:lumMod val="75000"/>
                </a:schemeClr>
              </a:solidFill>
            </a:endParaRP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E076A678-F259-791B-EFD8-FBD4DB61293D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5629" t="3790" r="6539" b="6153"/>
          <a:stretch/>
        </p:blipFill>
        <p:spPr>
          <a:xfrm>
            <a:off x="0" y="426644"/>
            <a:ext cx="7518288" cy="545376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26018898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3D74F674-13B7-C5E7-03FD-DAB7C7F11587}"/>
              </a:ext>
            </a:extLst>
          </p:cNvPr>
          <p:cNvSpPr txBox="1"/>
          <p:nvPr/>
        </p:nvSpPr>
        <p:spPr>
          <a:xfrm>
            <a:off x="3318109" y="1100766"/>
            <a:ext cx="4187923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400" b="1" dirty="0"/>
              <a:t>Supplementary Table 7: Preparation of stock solutions</a:t>
            </a:r>
            <a:endParaRPr lang="en-SA" sz="1400" b="1" dirty="0"/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0F4CE81C-BFE7-81AA-C6FA-8690B21B435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25640" y="1524583"/>
            <a:ext cx="6218561" cy="298380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01891784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3D74F674-13B7-C5E7-03FD-DAB7C7F11587}"/>
              </a:ext>
            </a:extLst>
          </p:cNvPr>
          <p:cNvSpPr txBox="1"/>
          <p:nvPr/>
        </p:nvSpPr>
        <p:spPr>
          <a:xfrm>
            <a:off x="1597929" y="1492415"/>
            <a:ext cx="7371141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400" b="1" dirty="0"/>
              <a:t>Supplementary Table 8: Regression Equations for Revertants (y) with Respect to Concentration (x)</a:t>
            </a:r>
            <a:endParaRPr lang="en-SA" sz="1400" b="1" dirty="0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ED7CEC2B-0F87-E196-B672-6FCC5A39A963}"/>
              </a:ext>
            </a:extLst>
          </p:cNvPr>
          <p:cNvSpPr txBox="1"/>
          <p:nvPr/>
        </p:nvSpPr>
        <p:spPr>
          <a:xfrm>
            <a:off x="1904864" y="4509556"/>
            <a:ext cx="3175000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900" b="1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Correlation coefficient, # = 5% v/v S9 mix. 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31778FEC-3F03-024D-4685-4AE00E23FEDE}"/>
              </a:ext>
            </a:extLst>
          </p:cNvPr>
          <p:cNvSpPr txBox="1"/>
          <p:nvPr/>
        </p:nvSpPr>
        <p:spPr>
          <a:xfrm>
            <a:off x="7112138" y="4431309"/>
            <a:ext cx="3175000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900" b="1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Correlation coefficient, # = 5% v/v S9 mix. </a:t>
            </a:r>
          </a:p>
        </p:txBody>
      </p:sp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id="{A79EDED7-E449-4025-D5CC-8DCB90443315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218972764"/>
              </p:ext>
            </p:extLst>
          </p:nvPr>
        </p:nvGraphicFramePr>
        <p:xfrm>
          <a:off x="784860" y="1993499"/>
          <a:ext cx="4825666" cy="2438400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708076">
                  <a:extLst>
                    <a:ext uri="{9D8B030D-6E8A-4147-A177-3AD203B41FA5}">
                      <a16:colId xmlns:a16="http://schemas.microsoft.com/office/drawing/2014/main" val="320587763"/>
                    </a:ext>
                  </a:extLst>
                </a:gridCol>
                <a:gridCol w="1827848">
                  <a:extLst>
                    <a:ext uri="{9D8B030D-6E8A-4147-A177-3AD203B41FA5}">
                      <a16:colId xmlns:a16="http://schemas.microsoft.com/office/drawing/2014/main" val="94250224"/>
                    </a:ext>
                  </a:extLst>
                </a:gridCol>
                <a:gridCol w="2289742">
                  <a:extLst>
                    <a:ext uri="{9D8B030D-6E8A-4147-A177-3AD203B41FA5}">
                      <a16:colId xmlns:a16="http://schemas.microsoft.com/office/drawing/2014/main" val="902007829"/>
                    </a:ext>
                  </a:extLst>
                </a:gridCol>
              </a:tblGrid>
              <a:tr h="203200">
                <a:tc rowSpan="2">
                  <a:txBody>
                    <a:bodyPr/>
                    <a:lstStyle/>
                    <a:p>
                      <a:pPr algn="l"/>
                      <a:r>
                        <a:rPr lang="en-SA" sz="1100" b="1" dirty="0">
                          <a:effectLst/>
                        </a:rPr>
                        <a:t>Strain</a:t>
                      </a:r>
                      <a:endParaRPr lang="en-SA" sz="1800" b="1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SA" sz="1200" b="1" dirty="0">
                          <a:effectLst/>
                        </a:rPr>
                        <a:t>Mutagenicity Test</a:t>
                      </a:r>
                      <a:r>
                        <a:rPr lang="en-US" sz="1200" b="1" dirty="0">
                          <a:effectLst/>
                        </a:rPr>
                        <a:t> MP3</a:t>
                      </a:r>
                      <a:endParaRPr lang="en-SA" sz="2000" b="1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/>
                </a:tc>
                <a:tc hMerge="1">
                  <a:txBody>
                    <a:bodyPr/>
                    <a:lstStyle/>
                    <a:p>
                      <a:endParaRPr lang="en-SA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201893288"/>
                  </a:ext>
                </a:extLst>
              </a:tr>
              <a:tr h="203200">
                <a:tc vMerge="1">
                  <a:txBody>
                    <a:bodyPr/>
                    <a:lstStyle/>
                    <a:p>
                      <a:endParaRPr lang="en-SA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SA" sz="900" b="1" dirty="0">
                          <a:effectLst/>
                        </a:rPr>
                        <a:t>In Absence of Metabolic Activation</a:t>
                      </a:r>
                      <a:endParaRPr lang="en-SA" sz="1200" b="1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r>
                        <a:rPr lang="en-SA" sz="900" b="1" dirty="0">
                          <a:effectLst/>
                        </a:rPr>
                        <a:t>In Presence of # Metabolic Activation</a:t>
                      </a:r>
                      <a:endParaRPr lang="en-SA" sz="1200" b="1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/>
                </a:tc>
                <a:extLst>
                  <a:ext uri="{0D108BD9-81ED-4DB2-BD59-A6C34878D82A}">
                    <a16:rowId xmlns:a16="http://schemas.microsoft.com/office/drawing/2014/main" val="2764848938"/>
                  </a:ext>
                </a:extLst>
              </a:tr>
              <a:tr h="203200">
                <a:tc rowSpan="2">
                  <a:txBody>
                    <a:bodyPr/>
                    <a:lstStyle/>
                    <a:p>
                      <a:pPr algn="l"/>
                      <a:r>
                        <a:rPr lang="en-SA" sz="1100" b="1" dirty="0">
                          <a:effectLst/>
                        </a:rPr>
                        <a:t>TA1537 </a:t>
                      </a:r>
                      <a:endParaRPr lang="en-SA" sz="1800" b="1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r>
                        <a:rPr lang="en-SA" sz="900" b="1" dirty="0">
                          <a:effectLst/>
                        </a:rPr>
                        <a:t>y = 0.00003 x + 7.13895 </a:t>
                      </a:r>
                      <a:endParaRPr lang="en-SA" sz="1200" b="1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r>
                        <a:rPr lang="en-SA" sz="900" b="1">
                          <a:effectLst/>
                        </a:rPr>
                        <a:t>y = -0.00002 x + 7.24132 </a:t>
                      </a:r>
                      <a:endParaRPr lang="en-SA" sz="1200" b="1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/>
                </a:tc>
                <a:extLst>
                  <a:ext uri="{0D108BD9-81ED-4DB2-BD59-A6C34878D82A}">
                    <a16:rowId xmlns:a16="http://schemas.microsoft.com/office/drawing/2014/main" val="15968461"/>
                  </a:ext>
                </a:extLst>
              </a:tr>
              <a:tr h="203200">
                <a:tc vMerge="1">
                  <a:txBody>
                    <a:bodyPr/>
                    <a:lstStyle/>
                    <a:p>
                      <a:endParaRPr lang="en-SA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SA" sz="900" b="1" dirty="0">
                          <a:effectLst/>
                        </a:rPr>
                        <a:t>R = 0.05523 </a:t>
                      </a:r>
                      <a:endParaRPr lang="en-SA" sz="1200" b="1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r>
                        <a:rPr lang="en-SA" sz="900" b="1" dirty="0">
                          <a:effectLst/>
                        </a:rPr>
                        <a:t>R = -0.04708 </a:t>
                      </a:r>
                      <a:endParaRPr lang="en-SA" sz="1200" b="1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/>
                </a:tc>
                <a:extLst>
                  <a:ext uri="{0D108BD9-81ED-4DB2-BD59-A6C34878D82A}">
                    <a16:rowId xmlns:a16="http://schemas.microsoft.com/office/drawing/2014/main" val="3439152125"/>
                  </a:ext>
                </a:extLst>
              </a:tr>
              <a:tr h="203200">
                <a:tc rowSpan="2">
                  <a:txBody>
                    <a:bodyPr/>
                    <a:lstStyle/>
                    <a:p>
                      <a:pPr algn="l"/>
                      <a:r>
                        <a:rPr lang="en-SA" sz="1100" b="1" dirty="0">
                          <a:effectLst/>
                        </a:rPr>
                        <a:t>TA1535 </a:t>
                      </a:r>
                      <a:endParaRPr lang="en-SA" sz="1800" b="1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r>
                        <a:rPr lang="en-SA" sz="900" b="1">
                          <a:effectLst/>
                        </a:rPr>
                        <a:t>y = -0.00017 x + 15.63819 </a:t>
                      </a:r>
                      <a:endParaRPr lang="en-SA" sz="1200" b="1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r>
                        <a:rPr lang="en-SA" sz="900" b="1" dirty="0">
                          <a:effectLst/>
                        </a:rPr>
                        <a:t>y = 0.00058 x + 15.42415 </a:t>
                      </a:r>
                      <a:endParaRPr lang="en-SA" sz="1200" b="1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/>
                </a:tc>
                <a:extLst>
                  <a:ext uri="{0D108BD9-81ED-4DB2-BD59-A6C34878D82A}">
                    <a16:rowId xmlns:a16="http://schemas.microsoft.com/office/drawing/2014/main" val="1175637875"/>
                  </a:ext>
                </a:extLst>
              </a:tr>
              <a:tr h="203200">
                <a:tc vMerge="1">
                  <a:txBody>
                    <a:bodyPr/>
                    <a:lstStyle/>
                    <a:p>
                      <a:endParaRPr lang="en-SA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SA" sz="900" b="1">
                          <a:effectLst/>
                        </a:rPr>
                        <a:t>R = -0.42913 </a:t>
                      </a:r>
                      <a:endParaRPr lang="en-SA" sz="1200" b="1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r>
                        <a:rPr lang="en-SA" sz="900" b="1" dirty="0">
                          <a:effectLst/>
                        </a:rPr>
                        <a:t>R = 0.71179 </a:t>
                      </a:r>
                      <a:endParaRPr lang="en-SA" sz="1200" b="1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/>
                </a:tc>
                <a:extLst>
                  <a:ext uri="{0D108BD9-81ED-4DB2-BD59-A6C34878D82A}">
                    <a16:rowId xmlns:a16="http://schemas.microsoft.com/office/drawing/2014/main" val="327844675"/>
                  </a:ext>
                </a:extLst>
              </a:tr>
              <a:tr h="203200">
                <a:tc rowSpan="2">
                  <a:txBody>
                    <a:bodyPr/>
                    <a:lstStyle/>
                    <a:p>
                      <a:pPr algn="l"/>
                      <a:r>
                        <a:rPr lang="en-SA" sz="1100" b="1" dirty="0">
                          <a:effectLst/>
                        </a:rPr>
                        <a:t>TA98 </a:t>
                      </a:r>
                      <a:endParaRPr lang="en-SA" sz="1800" b="1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r>
                        <a:rPr lang="en-SA" sz="900" b="1">
                          <a:effectLst/>
                        </a:rPr>
                        <a:t>y = 0.00034 x + 23.22691 </a:t>
                      </a:r>
                      <a:endParaRPr lang="en-SA" sz="1200" b="1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r>
                        <a:rPr lang="en-SA" sz="900" b="1" dirty="0">
                          <a:effectLst/>
                        </a:rPr>
                        <a:t>y = -0.00005 x + 23.53644 </a:t>
                      </a:r>
                      <a:endParaRPr lang="en-SA" sz="1200" b="1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/>
                </a:tc>
                <a:extLst>
                  <a:ext uri="{0D108BD9-81ED-4DB2-BD59-A6C34878D82A}">
                    <a16:rowId xmlns:a16="http://schemas.microsoft.com/office/drawing/2014/main" val="3913799581"/>
                  </a:ext>
                </a:extLst>
              </a:tr>
              <a:tr h="203200">
                <a:tc vMerge="1">
                  <a:txBody>
                    <a:bodyPr/>
                    <a:lstStyle/>
                    <a:p>
                      <a:endParaRPr lang="en-SA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SA" sz="900" b="1">
                          <a:effectLst/>
                        </a:rPr>
                        <a:t>R = 0.70954 </a:t>
                      </a:r>
                      <a:endParaRPr lang="en-SA" sz="1200" b="1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r>
                        <a:rPr lang="en-SA" sz="900" b="1" dirty="0">
                          <a:effectLst/>
                        </a:rPr>
                        <a:t>R = -0.04795 </a:t>
                      </a:r>
                      <a:endParaRPr lang="en-SA" sz="1200" b="1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/>
                </a:tc>
                <a:extLst>
                  <a:ext uri="{0D108BD9-81ED-4DB2-BD59-A6C34878D82A}">
                    <a16:rowId xmlns:a16="http://schemas.microsoft.com/office/drawing/2014/main" val="1978265782"/>
                  </a:ext>
                </a:extLst>
              </a:tr>
              <a:tr h="203200">
                <a:tc rowSpan="2">
                  <a:txBody>
                    <a:bodyPr/>
                    <a:lstStyle/>
                    <a:p>
                      <a:pPr algn="l"/>
                      <a:r>
                        <a:rPr lang="en-SA" sz="1100" b="1" dirty="0">
                          <a:effectLst/>
                        </a:rPr>
                        <a:t>TA100 </a:t>
                      </a:r>
                      <a:endParaRPr lang="en-SA" sz="1800" b="1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r>
                        <a:rPr lang="en-SA" sz="900" b="1">
                          <a:effectLst/>
                        </a:rPr>
                        <a:t>y = -0.00172 x + 127.99184 </a:t>
                      </a:r>
                      <a:endParaRPr lang="en-SA" sz="1200" b="1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r>
                        <a:rPr lang="en-SA" sz="900" b="1" dirty="0">
                          <a:effectLst/>
                        </a:rPr>
                        <a:t>y = 0.00233 x + 132.96181 </a:t>
                      </a:r>
                      <a:endParaRPr lang="en-SA" sz="1200" b="1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/>
                </a:tc>
                <a:extLst>
                  <a:ext uri="{0D108BD9-81ED-4DB2-BD59-A6C34878D82A}">
                    <a16:rowId xmlns:a16="http://schemas.microsoft.com/office/drawing/2014/main" val="643859798"/>
                  </a:ext>
                </a:extLst>
              </a:tr>
              <a:tr h="203200">
                <a:tc vMerge="1">
                  <a:txBody>
                    <a:bodyPr/>
                    <a:lstStyle/>
                    <a:p>
                      <a:endParaRPr lang="en-SA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SA" sz="900" b="1">
                          <a:effectLst/>
                        </a:rPr>
                        <a:t>R = -0.68686 </a:t>
                      </a:r>
                      <a:endParaRPr lang="en-SA" sz="1200" b="1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r>
                        <a:rPr lang="en-SA" sz="900" b="1" dirty="0">
                          <a:effectLst/>
                        </a:rPr>
                        <a:t>R = 0.62671 </a:t>
                      </a:r>
                      <a:endParaRPr lang="en-SA" sz="1200" b="1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/>
                </a:tc>
                <a:extLst>
                  <a:ext uri="{0D108BD9-81ED-4DB2-BD59-A6C34878D82A}">
                    <a16:rowId xmlns:a16="http://schemas.microsoft.com/office/drawing/2014/main" val="1025704607"/>
                  </a:ext>
                </a:extLst>
              </a:tr>
              <a:tr h="203200">
                <a:tc rowSpan="2">
                  <a:txBody>
                    <a:bodyPr/>
                    <a:lstStyle/>
                    <a:p>
                      <a:pPr algn="l"/>
                      <a:r>
                        <a:rPr lang="en-SA" sz="1100" b="1" dirty="0">
                          <a:effectLst/>
                        </a:rPr>
                        <a:t>TA102 </a:t>
                      </a:r>
                      <a:endParaRPr lang="en-SA" sz="1800" b="1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r>
                        <a:rPr lang="en-SA" sz="900" b="1">
                          <a:effectLst/>
                        </a:rPr>
                        <a:t>y = 0.00130 x + 230.12739 </a:t>
                      </a:r>
                      <a:endParaRPr lang="en-SA" sz="1200" b="1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r>
                        <a:rPr lang="en-SA" sz="900" b="1" dirty="0">
                          <a:effectLst/>
                        </a:rPr>
                        <a:t>y = 0.00027 x + 227.50709 </a:t>
                      </a:r>
                      <a:endParaRPr lang="en-SA" sz="1200" b="1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/>
                </a:tc>
                <a:extLst>
                  <a:ext uri="{0D108BD9-81ED-4DB2-BD59-A6C34878D82A}">
                    <a16:rowId xmlns:a16="http://schemas.microsoft.com/office/drawing/2014/main" val="2845820523"/>
                  </a:ext>
                </a:extLst>
              </a:tr>
              <a:tr h="203200">
                <a:tc vMerge="1">
                  <a:txBody>
                    <a:bodyPr/>
                    <a:lstStyle/>
                    <a:p>
                      <a:endParaRPr lang="en-SA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SA" sz="900" b="1">
                          <a:effectLst/>
                        </a:rPr>
                        <a:t>R = 0.40163 </a:t>
                      </a:r>
                      <a:endParaRPr lang="en-SA" sz="1200" b="1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r>
                        <a:rPr lang="en-SA" sz="900" b="1" dirty="0">
                          <a:effectLst/>
                        </a:rPr>
                        <a:t>R = 0.14331 </a:t>
                      </a:r>
                      <a:endParaRPr lang="en-SA" sz="1200" b="1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/>
                </a:tc>
                <a:extLst>
                  <a:ext uri="{0D108BD9-81ED-4DB2-BD59-A6C34878D82A}">
                    <a16:rowId xmlns:a16="http://schemas.microsoft.com/office/drawing/2014/main" val="734720506"/>
                  </a:ext>
                </a:extLst>
              </a:tr>
            </a:tbl>
          </a:graphicData>
        </a:graphic>
      </p:graphicFrame>
      <p:graphicFrame>
        <p:nvGraphicFramePr>
          <p:cNvPr id="3" name="Table 2">
            <a:extLst>
              <a:ext uri="{FF2B5EF4-FFF2-40B4-BE49-F238E27FC236}">
                <a16:creationId xmlns:a16="http://schemas.microsoft.com/office/drawing/2014/main" id="{503CAA23-5537-850A-EE1A-E873659C18BF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312825393"/>
              </p:ext>
            </p:extLst>
          </p:nvPr>
        </p:nvGraphicFramePr>
        <p:xfrm>
          <a:off x="5909566" y="1992909"/>
          <a:ext cx="4825666" cy="2438400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655287">
                  <a:extLst>
                    <a:ext uri="{9D8B030D-6E8A-4147-A177-3AD203B41FA5}">
                      <a16:colId xmlns:a16="http://schemas.microsoft.com/office/drawing/2014/main" val="878735708"/>
                    </a:ext>
                  </a:extLst>
                </a:gridCol>
                <a:gridCol w="1883965">
                  <a:extLst>
                    <a:ext uri="{9D8B030D-6E8A-4147-A177-3AD203B41FA5}">
                      <a16:colId xmlns:a16="http://schemas.microsoft.com/office/drawing/2014/main" val="1147615696"/>
                    </a:ext>
                  </a:extLst>
                </a:gridCol>
                <a:gridCol w="2286414">
                  <a:extLst>
                    <a:ext uri="{9D8B030D-6E8A-4147-A177-3AD203B41FA5}">
                      <a16:colId xmlns:a16="http://schemas.microsoft.com/office/drawing/2014/main" val="3986398521"/>
                    </a:ext>
                  </a:extLst>
                </a:gridCol>
              </a:tblGrid>
              <a:tr h="203200">
                <a:tc rowSpan="2">
                  <a:txBody>
                    <a:bodyPr/>
                    <a:lstStyle/>
                    <a:p>
                      <a:pPr algn="l"/>
                      <a:r>
                        <a:rPr lang="en-SA" sz="1100" dirty="0">
                          <a:effectLst/>
                        </a:rPr>
                        <a:t>Strain</a:t>
                      </a:r>
                      <a:endParaRPr lang="en-SA" sz="18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SA" sz="1200" dirty="0">
                          <a:effectLst/>
                        </a:rPr>
                        <a:t>Mutagenicity Test</a:t>
                      </a:r>
                      <a:r>
                        <a:rPr lang="en-US" sz="1200" dirty="0">
                          <a:effectLst/>
                        </a:rPr>
                        <a:t> Nijmegen-1</a:t>
                      </a:r>
                      <a:endParaRPr lang="en-SA" sz="2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/>
                </a:tc>
                <a:tc hMerge="1">
                  <a:txBody>
                    <a:bodyPr/>
                    <a:lstStyle/>
                    <a:p>
                      <a:endParaRPr lang="en-SA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626886970"/>
                  </a:ext>
                </a:extLst>
              </a:tr>
              <a:tr h="203200">
                <a:tc vMerge="1">
                  <a:txBody>
                    <a:bodyPr/>
                    <a:lstStyle/>
                    <a:p>
                      <a:endParaRPr lang="en-SA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SA" sz="900">
                          <a:effectLst/>
                        </a:rPr>
                        <a:t>In Absence of Metabolic Activation </a:t>
                      </a:r>
                      <a:endParaRPr lang="en-SA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r>
                        <a:rPr lang="en-SA" sz="900">
                          <a:effectLst/>
                        </a:rPr>
                        <a:t>In Presence of # Metabolic Activation </a:t>
                      </a:r>
                      <a:endParaRPr lang="en-SA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/>
                </a:tc>
                <a:extLst>
                  <a:ext uri="{0D108BD9-81ED-4DB2-BD59-A6C34878D82A}">
                    <a16:rowId xmlns:a16="http://schemas.microsoft.com/office/drawing/2014/main" val="3958596445"/>
                  </a:ext>
                </a:extLst>
              </a:tr>
              <a:tr h="203200">
                <a:tc rowSpan="2">
                  <a:txBody>
                    <a:bodyPr/>
                    <a:lstStyle/>
                    <a:p>
                      <a:pPr algn="l"/>
                      <a:r>
                        <a:rPr lang="en-SA" sz="1100" dirty="0">
                          <a:effectLst/>
                        </a:rPr>
                        <a:t>TA1537 </a:t>
                      </a:r>
                      <a:endParaRPr lang="en-SA" sz="18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r>
                        <a:rPr lang="en-SA" sz="900">
                          <a:effectLst/>
                        </a:rPr>
                        <a:t>y = -0.00011 x + 5.91935 </a:t>
                      </a:r>
                      <a:endParaRPr lang="en-SA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r>
                        <a:rPr lang="en-SA" sz="900">
                          <a:effectLst/>
                        </a:rPr>
                        <a:t>y = -0.00022 x + 6.68050 </a:t>
                      </a:r>
                      <a:endParaRPr lang="en-SA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/>
                </a:tc>
                <a:extLst>
                  <a:ext uri="{0D108BD9-81ED-4DB2-BD59-A6C34878D82A}">
                    <a16:rowId xmlns:a16="http://schemas.microsoft.com/office/drawing/2014/main" val="450476545"/>
                  </a:ext>
                </a:extLst>
              </a:tr>
              <a:tr h="203200">
                <a:tc vMerge="1">
                  <a:txBody>
                    <a:bodyPr/>
                    <a:lstStyle/>
                    <a:p>
                      <a:endParaRPr lang="en-SA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SA" sz="900">
                          <a:effectLst/>
                        </a:rPr>
                        <a:t>R = -0.11946 </a:t>
                      </a:r>
                      <a:endParaRPr lang="en-SA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r>
                        <a:rPr lang="en-SA" sz="900">
                          <a:effectLst/>
                        </a:rPr>
                        <a:t>R = -0.32363 </a:t>
                      </a:r>
                      <a:endParaRPr lang="en-SA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/>
                </a:tc>
                <a:extLst>
                  <a:ext uri="{0D108BD9-81ED-4DB2-BD59-A6C34878D82A}">
                    <a16:rowId xmlns:a16="http://schemas.microsoft.com/office/drawing/2014/main" val="3967166520"/>
                  </a:ext>
                </a:extLst>
              </a:tr>
              <a:tr h="203200">
                <a:tc rowSpan="2">
                  <a:txBody>
                    <a:bodyPr/>
                    <a:lstStyle/>
                    <a:p>
                      <a:pPr algn="l"/>
                      <a:r>
                        <a:rPr lang="en-SA" sz="1100" dirty="0">
                          <a:effectLst/>
                        </a:rPr>
                        <a:t>TA1535 </a:t>
                      </a:r>
                      <a:endParaRPr lang="en-SA" sz="18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r>
                        <a:rPr lang="en-SA" sz="900">
                          <a:effectLst/>
                        </a:rPr>
                        <a:t>y = 0.00032 x + 14.96860 </a:t>
                      </a:r>
                      <a:endParaRPr lang="en-SA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r>
                        <a:rPr lang="en-SA" sz="900">
                          <a:effectLst/>
                        </a:rPr>
                        <a:t>y = 0.00006 x + 15.73092 </a:t>
                      </a:r>
                      <a:endParaRPr lang="en-SA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/>
                </a:tc>
                <a:extLst>
                  <a:ext uri="{0D108BD9-81ED-4DB2-BD59-A6C34878D82A}">
                    <a16:rowId xmlns:a16="http://schemas.microsoft.com/office/drawing/2014/main" val="200459398"/>
                  </a:ext>
                </a:extLst>
              </a:tr>
              <a:tr h="203200">
                <a:tc vMerge="1">
                  <a:txBody>
                    <a:bodyPr/>
                    <a:lstStyle/>
                    <a:p>
                      <a:endParaRPr lang="en-SA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SA" sz="900">
                          <a:effectLst/>
                        </a:rPr>
                        <a:t>R = 0.48964 </a:t>
                      </a:r>
                      <a:endParaRPr lang="en-SA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r>
                        <a:rPr lang="en-SA" sz="900">
                          <a:effectLst/>
                        </a:rPr>
                        <a:t>R = 0.10249 </a:t>
                      </a:r>
                      <a:endParaRPr lang="en-SA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/>
                </a:tc>
                <a:extLst>
                  <a:ext uri="{0D108BD9-81ED-4DB2-BD59-A6C34878D82A}">
                    <a16:rowId xmlns:a16="http://schemas.microsoft.com/office/drawing/2014/main" val="300754388"/>
                  </a:ext>
                </a:extLst>
              </a:tr>
              <a:tr h="203200">
                <a:tc rowSpan="2">
                  <a:txBody>
                    <a:bodyPr/>
                    <a:lstStyle/>
                    <a:p>
                      <a:pPr algn="l"/>
                      <a:r>
                        <a:rPr lang="en-SA" sz="1100" dirty="0">
                          <a:effectLst/>
                        </a:rPr>
                        <a:t>TA98 </a:t>
                      </a:r>
                      <a:endParaRPr lang="en-SA" sz="18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r>
                        <a:rPr lang="en-SA" sz="900">
                          <a:effectLst/>
                        </a:rPr>
                        <a:t>y = 0.00038 x + 23.97537 </a:t>
                      </a:r>
                      <a:endParaRPr lang="en-SA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r>
                        <a:rPr lang="en-SA" sz="900">
                          <a:effectLst/>
                        </a:rPr>
                        <a:t>y = -0.00014 x + 23.60941 </a:t>
                      </a:r>
                      <a:endParaRPr lang="en-SA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/>
                </a:tc>
                <a:extLst>
                  <a:ext uri="{0D108BD9-81ED-4DB2-BD59-A6C34878D82A}">
                    <a16:rowId xmlns:a16="http://schemas.microsoft.com/office/drawing/2014/main" val="3338279648"/>
                  </a:ext>
                </a:extLst>
              </a:tr>
              <a:tr h="203200">
                <a:tc vMerge="1">
                  <a:txBody>
                    <a:bodyPr/>
                    <a:lstStyle/>
                    <a:p>
                      <a:endParaRPr lang="en-SA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SA" sz="900">
                          <a:effectLst/>
                        </a:rPr>
                        <a:t>R = 0.38751 </a:t>
                      </a:r>
                      <a:endParaRPr lang="en-SA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r>
                        <a:rPr lang="en-SA" sz="900">
                          <a:effectLst/>
                        </a:rPr>
                        <a:t>R = -0.13708 </a:t>
                      </a:r>
                      <a:endParaRPr lang="en-SA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/>
                </a:tc>
                <a:extLst>
                  <a:ext uri="{0D108BD9-81ED-4DB2-BD59-A6C34878D82A}">
                    <a16:rowId xmlns:a16="http://schemas.microsoft.com/office/drawing/2014/main" val="259486078"/>
                  </a:ext>
                </a:extLst>
              </a:tr>
              <a:tr h="203200">
                <a:tc rowSpan="2">
                  <a:txBody>
                    <a:bodyPr/>
                    <a:lstStyle/>
                    <a:p>
                      <a:pPr algn="l"/>
                      <a:r>
                        <a:rPr lang="en-SA" sz="1100" dirty="0">
                          <a:effectLst/>
                        </a:rPr>
                        <a:t>TA100 </a:t>
                      </a:r>
                      <a:endParaRPr lang="en-SA" sz="18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r>
                        <a:rPr lang="en-SA" sz="900">
                          <a:effectLst/>
                        </a:rPr>
                        <a:t>y = -0.00264 x + 133.51058 </a:t>
                      </a:r>
                      <a:endParaRPr lang="en-SA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r>
                        <a:rPr lang="en-SA" sz="900">
                          <a:effectLst/>
                        </a:rPr>
                        <a:t>y = 0.00288 x + 129.85406 </a:t>
                      </a:r>
                      <a:endParaRPr lang="en-SA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/>
                </a:tc>
                <a:extLst>
                  <a:ext uri="{0D108BD9-81ED-4DB2-BD59-A6C34878D82A}">
                    <a16:rowId xmlns:a16="http://schemas.microsoft.com/office/drawing/2014/main" val="3375750300"/>
                  </a:ext>
                </a:extLst>
              </a:tr>
              <a:tr h="203200">
                <a:tc vMerge="1">
                  <a:txBody>
                    <a:bodyPr/>
                    <a:lstStyle/>
                    <a:p>
                      <a:endParaRPr lang="en-SA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SA" sz="900">
                          <a:effectLst/>
                        </a:rPr>
                        <a:t>R = -0.35992 </a:t>
                      </a:r>
                      <a:endParaRPr lang="en-SA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r>
                        <a:rPr lang="en-SA" sz="900">
                          <a:effectLst/>
                        </a:rPr>
                        <a:t>R = 0.40537 </a:t>
                      </a:r>
                      <a:endParaRPr lang="en-SA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/>
                </a:tc>
                <a:extLst>
                  <a:ext uri="{0D108BD9-81ED-4DB2-BD59-A6C34878D82A}">
                    <a16:rowId xmlns:a16="http://schemas.microsoft.com/office/drawing/2014/main" val="3374398564"/>
                  </a:ext>
                </a:extLst>
              </a:tr>
              <a:tr h="203200">
                <a:tc rowSpan="2">
                  <a:txBody>
                    <a:bodyPr/>
                    <a:lstStyle/>
                    <a:p>
                      <a:pPr algn="l"/>
                      <a:r>
                        <a:rPr lang="en-SA" sz="1100" dirty="0">
                          <a:effectLst/>
                        </a:rPr>
                        <a:t>TA102 </a:t>
                      </a:r>
                      <a:endParaRPr lang="en-SA" sz="18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r>
                        <a:rPr lang="en-SA" sz="900">
                          <a:effectLst/>
                        </a:rPr>
                        <a:t>y = -0.00105 x + 226.56683 </a:t>
                      </a:r>
                      <a:endParaRPr lang="en-SA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r>
                        <a:rPr lang="en-SA" sz="900">
                          <a:effectLst/>
                        </a:rPr>
                        <a:t>y = 0.00157 x + 230.01869 </a:t>
                      </a:r>
                      <a:endParaRPr lang="en-SA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/>
                </a:tc>
                <a:extLst>
                  <a:ext uri="{0D108BD9-81ED-4DB2-BD59-A6C34878D82A}">
                    <a16:rowId xmlns:a16="http://schemas.microsoft.com/office/drawing/2014/main" val="1378483268"/>
                  </a:ext>
                </a:extLst>
              </a:tr>
              <a:tr h="203200">
                <a:tc vMerge="1">
                  <a:txBody>
                    <a:bodyPr/>
                    <a:lstStyle/>
                    <a:p>
                      <a:endParaRPr lang="en-SA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SA" sz="900">
                          <a:effectLst/>
                        </a:rPr>
                        <a:t>R = -0.22645 </a:t>
                      </a:r>
                      <a:endParaRPr lang="en-SA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r>
                        <a:rPr lang="en-SA" sz="900" dirty="0">
                          <a:effectLst/>
                        </a:rPr>
                        <a:t>R = 0.41081 </a:t>
                      </a:r>
                      <a:endParaRPr lang="en-SA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/>
                </a:tc>
                <a:extLst>
                  <a:ext uri="{0D108BD9-81ED-4DB2-BD59-A6C34878D82A}">
                    <a16:rowId xmlns:a16="http://schemas.microsoft.com/office/drawing/2014/main" val="1015979287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81894665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7C5B04EC-EB93-48E2-62B0-857E99EC7963}"/>
              </a:ext>
            </a:extLst>
          </p:cNvPr>
          <p:cNvSpPr txBox="1"/>
          <p:nvPr/>
        </p:nvSpPr>
        <p:spPr>
          <a:xfrm>
            <a:off x="3251000" y="0"/>
            <a:ext cx="114967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Nijmegen-1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8E9206A5-5EF8-7A63-8C47-ADC5FACFECAC}"/>
              </a:ext>
            </a:extLst>
          </p:cNvPr>
          <p:cNvSpPr txBox="1"/>
          <p:nvPr/>
        </p:nvSpPr>
        <p:spPr>
          <a:xfrm>
            <a:off x="388314" y="5800298"/>
            <a:ext cx="641714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SA" sz="14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2: </a:t>
            </a: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The characterization of Nijmegen-1 by </a:t>
            </a:r>
            <a:r>
              <a:rPr lang="en-US" sz="14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H NMR . </a:t>
            </a:r>
            <a:endParaRPr lang="en-SA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0E0865A6-5106-B219-B430-DCA6956C58F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454254" y="546728"/>
            <a:ext cx="4511939" cy="2882272"/>
          </a:xfrm>
          <a:prstGeom prst="rect">
            <a:avLst/>
          </a:prstGeom>
        </p:spPr>
      </p:pic>
      <p:sp>
        <p:nvSpPr>
          <p:cNvPr id="7" name="Rectangle 4">
            <a:extLst>
              <a:ext uri="{FF2B5EF4-FFF2-40B4-BE49-F238E27FC236}">
                <a16:creationId xmlns:a16="http://schemas.microsoft.com/office/drawing/2014/main" id="{4E5762C0-CCEA-1DED-9FF2-15090AFCD164}"/>
              </a:ext>
            </a:extLst>
          </p:cNvPr>
          <p:cNvSpPr>
            <a:spLocks noChangeArrowheads="1"/>
          </p:cNvSpPr>
          <p:nvPr/>
        </p:nvSpPr>
        <p:spPr bwMode="auto">
          <a:xfrm>
            <a:off x="7268346" y="4476859"/>
            <a:ext cx="4697847" cy="147732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0" tIns="0" rIns="0" bIns="0" numCol="1" anchor="ctr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SA" altLang="en-SA" sz="1200" b="1" i="0" u="none" strike="noStrike" cap="none" normalizeH="0" baseline="30000" dirty="0">
                <a:ln>
                  <a:noFill/>
                </a:ln>
                <a:solidFill>
                  <a:srgbClr val="1F1F1F"/>
                </a:solidFill>
                <a:effectLst/>
                <a:latin typeface="+mn-lt"/>
              </a:rPr>
              <a:t>1</a:t>
            </a:r>
            <a:r>
              <a:rPr kumimoji="0" lang="en-SA" altLang="en-SA" sz="1200" b="1" i="0" u="none" strike="noStrike" cap="none" normalizeH="0" baseline="0" dirty="0">
                <a:ln>
                  <a:noFill/>
                </a:ln>
                <a:solidFill>
                  <a:srgbClr val="1F1F1F"/>
                </a:solidFill>
                <a:effectLst/>
                <a:latin typeface="+mn-lt"/>
              </a:rPr>
              <a:t>H NMR (CDCl</a:t>
            </a:r>
            <a:r>
              <a:rPr kumimoji="0" lang="en-SA" altLang="en-SA" sz="1200" b="1" i="0" u="none" strike="noStrike" cap="none" normalizeH="0" baseline="-30000" dirty="0">
                <a:ln>
                  <a:noFill/>
                </a:ln>
                <a:solidFill>
                  <a:srgbClr val="1F1F1F"/>
                </a:solidFill>
                <a:effectLst/>
                <a:latin typeface="+mn-lt"/>
              </a:rPr>
              <a:t>3</a:t>
            </a:r>
            <a:r>
              <a:rPr kumimoji="0" lang="en-SA" altLang="en-SA" sz="1200" b="1" i="0" u="none" strike="noStrike" cap="none" normalizeH="0" baseline="0" dirty="0">
                <a:ln>
                  <a:noFill/>
                </a:ln>
                <a:solidFill>
                  <a:srgbClr val="1F1F1F"/>
                </a:solidFill>
                <a:effectLst/>
                <a:latin typeface="+mn-lt"/>
              </a:rPr>
              <a:t>, 400 MHz): </a:t>
            </a:r>
            <a:r>
              <a:rPr kumimoji="0" lang="en-SA" altLang="en-SA" sz="1200" b="1" i="1" u="none" strike="noStrike" cap="none" normalizeH="0" baseline="0" dirty="0">
                <a:ln>
                  <a:noFill/>
                </a:ln>
                <a:solidFill>
                  <a:srgbClr val="1F1F1F"/>
                </a:solidFill>
                <a:effectLst/>
                <a:latin typeface="+mn-lt"/>
              </a:rPr>
              <a:t>δ</a:t>
            </a:r>
            <a:r>
              <a:rPr kumimoji="0" lang="en-SA" altLang="en-SA" sz="1200" b="1" i="0" u="none" strike="noStrike" cap="none" normalizeH="0" baseline="0" dirty="0">
                <a:ln>
                  <a:noFill/>
                </a:ln>
                <a:solidFill>
                  <a:srgbClr val="1F1F1F"/>
                </a:solidFill>
                <a:effectLst/>
                <a:latin typeface="+mn-lt"/>
              </a:rPr>
              <a:t> 8.53–7.93 (m, 4H, ArH + CHO), 6.91 (s, 1H, CH), 6.20 (s, 1H, OCHO), 4.00 (s, 3H, CH</a:t>
            </a:r>
            <a:r>
              <a:rPr kumimoji="0" lang="en-SA" altLang="en-SA" sz="1200" b="1" i="0" u="none" strike="noStrike" cap="none" normalizeH="0" baseline="-30000" dirty="0">
                <a:ln>
                  <a:noFill/>
                </a:ln>
                <a:solidFill>
                  <a:srgbClr val="1F1F1F"/>
                </a:solidFill>
                <a:effectLst/>
                <a:latin typeface="+mn-lt"/>
              </a:rPr>
              <a:t>3</a:t>
            </a:r>
            <a:r>
              <a:rPr kumimoji="0" lang="en-SA" altLang="en-SA" sz="1200" b="1" i="0" u="none" strike="noStrike" cap="none" normalizeH="0" baseline="0" dirty="0">
                <a:ln>
                  <a:noFill/>
                </a:ln>
                <a:solidFill>
                  <a:srgbClr val="1F1F1F"/>
                </a:solidFill>
                <a:effectLst/>
                <a:latin typeface="+mn-lt"/>
              </a:rPr>
              <a:t>OCO), 3.79 (s, 3H, OCH</a:t>
            </a:r>
            <a:r>
              <a:rPr kumimoji="0" lang="en-SA" altLang="en-SA" sz="1200" b="1" i="0" u="none" strike="noStrike" cap="none" normalizeH="0" baseline="-30000" dirty="0">
                <a:ln>
                  <a:noFill/>
                </a:ln>
                <a:solidFill>
                  <a:srgbClr val="1F1F1F"/>
                </a:solidFill>
                <a:effectLst/>
                <a:latin typeface="+mn-lt"/>
              </a:rPr>
              <a:t>3</a:t>
            </a:r>
            <a:r>
              <a:rPr kumimoji="0" lang="en-SA" altLang="en-SA" sz="1200" b="1" i="0" u="none" strike="noStrike" cap="none" normalizeH="0" baseline="0" dirty="0">
                <a:ln>
                  <a:noFill/>
                </a:ln>
                <a:solidFill>
                  <a:srgbClr val="1F1F1F"/>
                </a:solidFill>
                <a:effectLst/>
                <a:latin typeface="+mn-lt"/>
              </a:rPr>
              <a:t>) 1.98 (s, 3H, CH</a:t>
            </a:r>
            <a:r>
              <a:rPr kumimoji="0" lang="en-SA" altLang="en-SA" sz="1200" b="1" i="0" u="none" strike="noStrike" cap="none" normalizeH="0" baseline="-30000" dirty="0">
                <a:ln>
                  <a:noFill/>
                </a:ln>
                <a:solidFill>
                  <a:srgbClr val="1F1F1F"/>
                </a:solidFill>
                <a:effectLst/>
                <a:latin typeface="+mn-lt"/>
              </a:rPr>
              <a:t>3</a:t>
            </a:r>
            <a:r>
              <a:rPr kumimoji="0" lang="en-SA" altLang="en-SA" sz="1200" b="1" i="0" u="none" strike="noStrike" cap="none" normalizeH="0" baseline="0" dirty="0">
                <a:ln>
                  <a:noFill/>
                </a:ln>
                <a:solidFill>
                  <a:srgbClr val="1F1F1F"/>
                </a:solidFill>
                <a:effectLst/>
                <a:latin typeface="+mn-lt"/>
              </a:rPr>
              <a:t>). </a:t>
            </a:r>
            <a:r>
              <a:rPr kumimoji="0" lang="en-SA" altLang="en-SA" sz="1200" b="1" i="0" u="none" strike="noStrike" cap="none" normalizeH="0" baseline="30000" dirty="0">
                <a:ln>
                  <a:noFill/>
                </a:ln>
                <a:solidFill>
                  <a:srgbClr val="1F1F1F"/>
                </a:solidFill>
                <a:effectLst/>
                <a:latin typeface="+mn-lt"/>
              </a:rPr>
              <a:t>13</a:t>
            </a:r>
            <a:r>
              <a:rPr kumimoji="0" lang="en-SA" altLang="en-SA" sz="1200" b="1" i="0" u="none" strike="noStrike" cap="none" normalizeH="0" baseline="0" dirty="0">
                <a:ln>
                  <a:noFill/>
                </a:ln>
                <a:solidFill>
                  <a:srgbClr val="1F1F1F"/>
                </a:solidFill>
                <a:effectLst/>
                <a:latin typeface="+mn-lt"/>
              </a:rPr>
              <a:t>C NMR, (CDCl</a:t>
            </a:r>
            <a:r>
              <a:rPr kumimoji="0" lang="en-SA" altLang="en-SA" sz="1200" b="1" i="0" u="none" strike="noStrike" cap="none" normalizeH="0" baseline="-30000" dirty="0">
                <a:ln>
                  <a:noFill/>
                </a:ln>
                <a:solidFill>
                  <a:srgbClr val="1F1F1F"/>
                </a:solidFill>
                <a:effectLst/>
                <a:latin typeface="+mn-lt"/>
              </a:rPr>
              <a:t>3</a:t>
            </a:r>
            <a:r>
              <a:rPr kumimoji="0" lang="en-SA" altLang="en-SA" sz="1200" b="1" i="0" u="none" strike="noStrike" cap="none" normalizeH="0" baseline="0" dirty="0">
                <a:ln>
                  <a:noFill/>
                </a:ln>
                <a:solidFill>
                  <a:srgbClr val="1F1F1F"/>
                </a:solidFill>
                <a:effectLst/>
                <a:latin typeface="+mn-lt"/>
              </a:rPr>
              <a:t>, 100 MHz): </a:t>
            </a:r>
            <a:r>
              <a:rPr kumimoji="0" lang="en-SA" altLang="en-SA" sz="1200" b="1" i="1" u="none" strike="noStrike" cap="none" normalizeH="0" baseline="0" dirty="0">
                <a:ln>
                  <a:noFill/>
                </a:ln>
                <a:solidFill>
                  <a:srgbClr val="1F1F1F"/>
                </a:solidFill>
                <a:effectLst/>
                <a:latin typeface="+mn-lt"/>
              </a:rPr>
              <a:t>δ</a:t>
            </a:r>
            <a:r>
              <a:rPr kumimoji="0" lang="en-SA" altLang="en-SA" sz="1200" b="1" i="0" u="none" strike="noStrike" cap="none" normalizeH="0" baseline="0" dirty="0">
                <a:ln>
                  <a:noFill/>
                </a:ln>
                <a:solidFill>
                  <a:srgbClr val="1F1F1F"/>
                </a:solidFill>
                <a:effectLst/>
                <a:latin typeface="+mn-lt"/>
              </a:rPr>
              <a:t> 169.9, 165.2, 162.9, 153.7, 140.9, 135.7, 132.3, 124.9, 123.9, 106.0, 100.1, 60.4, 52.9, 52.4, 31.8, 22.6, 14.2, 14.1, 10.7; MS [EI, </a:t>
            </a:r>
            <a:r>
              <a:rPr kumimoji="0" lang="en-SA" altLang="en-SA" sz="1200" b="1" i="1" u="none" strike="noStrike" cap="none" normalizeH="0" baseline="0" dirty="0">
                <a:ln>
                  <a:noFill/>
                </a:ln>
                <a:solidFill>
                  <a:srgbClr val="1F1F1F"/>
                </a:solidFill>
                <a:effectLst/>
                <a:latin typeface="+mn-lt"/>
              </a:rPr>
              <a:t>m</a:t>
            </a:r>
            <a:r>
              <a:rPr kumimoji="0" lang="en-SA" altLang="en-SA" sz="1200" b="1" i="0" u="none" strike="noStrike" cap="none" normalizeH="0" baseline="0" dirty="0">
                <a:ln>
                  <a:noFill/>
                </a:ln>
                <a:solidFill>
                  <a:srgbClr val="1F1F1F"/>
                </a:solidFill>
                <a:effectLst/>
                <a:latin typeface="+mn-lt"/>
              </a:rPr>
              <a:t>/</a:t>
            </a:r>
            <a:r>
              <a:rPr kumimoji="0" lang="en-SA" altLang="en-SA" sz="1200" b="1" i="1" u="none" strike="noStrike" cap="none" normalizeH="0" baseline="0" dirty="0">
                <a:ln>
                  <a:noFill/>
                </a:ln>
                <a:solidFill>
                  <a:srgbClr val="1F1F1F"/>
                </a:solidFill>
                <a:effectLst/>
                <a:latin typeface="+mn-lt"/>
              </a:rPr>
              <a:t>z</a:t>
            </a:r>
            <a:r>
              <a:rPr kumimoji="0" lang="en-SA" altLang="en-SA" sz="1200" b="1" i="0" u="none" strike="noStrike" cap="none" normalizeH="0" baseline="0" dirty="0">
                <a:ln>
                  <a:noFill/>
                </a:ln>
                <a:solidFill>
                  <a:srgbClr val="1F1F1F"/>
                </a:solidFill>
                <a:effectLst/>
                <a:latin typeface="+mn-lt"/>
              </a:rPr>
              <a:t>, rel. intensity (%)]: 402 ([M+1]</a:t>
            </a:r>
            <a:r>
              <a:rPr kumimoji="0" lang="en-SA" altLang="en-SA" sz="1200" b="1" i="0" u="none" strike="noStrike" cap="none" normalizeH="0" baseline="30000" dirty="0">
                <a:ln>
                  <a:noFill/>
                </a:ln>
                <a:solidFill>
                  <a:srgbClr val="1F1F1F"/>
                </a:solidFill>
                <a:effectLst/>
                <a:latin typeface="+mn-lt"/>
              </a:rPr>
              <a:t>+</a:t>
            </a:r>
            <a:r>
              <a:rPr kumimoji="0" lang="en-SA" altLang="en-SA" sz="1200" b="1" i="0" u="none" strike="noStrike" cap="none" normalizeH="0" baseline="0" dirty="0">
                <a:ln>
                  <a:noFill/>
                </a:ln>
                <a:solidFill>
                  <a:srgbClr val="1F1F1F"/>
                </a:solidFill>
                <a:effectLst/>
                <a:latin typeface="+mn-lt"/>
              </a:rPr>
              <a:t>, 0.8); 401 ([M]</a:t>
            </a:r>
            <a:r>
              <a:rPr kumimoji="0" lang="en-SA" altLang="en-SA" sz="1200" b="1" i="0" u="none" strike="noStrike" cap="none" normalizeH="0" baseline="30000" dirty="0">
                <a:ln>
                  <a:noFill/>
                </a:ln>
                <a:solidFill>
                  <a:srgbClr val="1F1F1F"/>
                </a:solidFill>
                <a:effectLst/>
                <a:latin typeface="+mn-lt"/>
              </a:rPr>
              <a:t>+</a:t>
            </a:r>
            <a:r>
              <a:rPr kumimoji="0" lang="en-SA" altLang="en-SA" sz="1200" b="1" i="0" u="none" strike="noStrike" cap="none" normalizeH="0" baseline="0" dirty="0">
                <a:ln>
                  <a:noFill/>
                </a:ln>
                <a:solidFill>
                  <a:srgbClr val="1F1F1F"/>
                </a:solidFill>
                <a:effectLst/>
                <a:latin typeface="+mn-lt"/>
              </a:rPr>
              <a:t>, 3.4); 370 ([M</a:t>
            </a:r>
            <a:r>
              <a:rPr kumimoji="0" lang="en-SA" altLang="en-SA" sz="1200" b="1" i="0" u="none" strike="noStrike" cap="none" normalizeH="0" baseline="30000" dirty="0">
                <a:ln>
                  <a:noFill/>
                </a:ln>
                <a:solidFill>
                  <a:srgbClr val="1F1F1F"/>
                </a:solidFill>
                <a:effectLst/>
                <a:latin typeface="+mn-lt"/>
              </a:rPr>
              <a:t>+</a:t>
            </a:r>
            <a:r>
              <a:rPr kumimoji="0" lang="en-SA" altLang="en-SA" sz="1200" b="1" i="0" u="none" strike="noStrike" cap="none" normalizeH="0" baseline="0" dirty="0">
                <a:ln>
                  <a:noFill/>
                </a:ln>
                <a:solidFill>
                  <a:srgbClr val="1F1F1F"/>
                </a:solidFill>
                <a:effectLst/>
                <a:latin typeface="+mn-lt"/>
              </a:rPr>
              <a:t>−31], [C</a:t>
            </a:r>
            <a:r>
              <a:rPr kumimoji="0" lang="en-SA" altLang="en-SA" sz="1200" b="1" i="0" u="none" strike="noStrike" cap="none" normalizeH="0" baseline="-30000" dirty="0">
                <a:ln>
                  <a:noFill/>
                </a:ln>
                <a:solidFill>
                  <a:srgbClr val="1F1F1F"/>
                </a:solidFill>
                <a:effectLst/>
                <a:latin typeface="+mn-lt"/>
              </a:rPr>
              <a:t>18</a:t>
            </a:r>
            <a:r>
              <a:rPr kumimoji="0" lang="en-SA" altLang="en-SA" sz="1200" b="1" i="0" u="none" strike="noStrike" cap="none" normalizeH="0" baseline="0" dirty="0">
                <a:ln>
                  <a:noFill/>
                </a:ln>
                <a:solidFill>
                  <a:srgbClr val="1F1F1F"/>
                </a:solidFill>
                <a:effectLst/>
                <a:latin typeface="+mn-lt"/>
              </a:rPr>
              <a:t>H</a:t>
            </a:r>
            <a:r>
              <a:rPr kumimoji="0" lang="en-SA" altLang="en-SA" sz="1200" b="1" i="0" u="none" strike="noStrike" cap="none" normalizeH="0" baseline="-30000" dirty="0">
                <a:ln>
                  <a:noFill/>
                </a:ln>
                <a:solidFill>
                  <a:srgbClr val="1F1F1F"/>
                </a:solidFill>
                <a:effectLst/>
                <a:latin typeface="+mn-lt"/>
              </a:rPr>
              <a:t>12</a:t>
            </a:r>
            <a:r>
              <a:rPr kumimoji="0" lang="en-SA" altLang="en-SA" sz="1200" b="1" i="0" u="none" strike="noStrike" cap="none" normalizeH="0" baseline="0" dirty="0">
                <a:ln>
                  <a:noFill/>
                </a:ln>
                <a:solidFill>
                  <a:srgbClr val="1F1F1F"/>
                </a:solidFill>
                <a:effectLst/>
                <a:latin typeface="+mn-lt"/>
              </a:rPr>
              <a:t>NO</a:t>
            </a:r>
            <a:r>
              <a:rPr kumimoji="0" lang="en-SA" altLang="en-SA" sz="1200" b="1" i="0" u="none" strike="noStrike" cap="none" normalizeH="0" baseline="-30000" dirty="0">
                <a:ln>
                  <a:noFill/>
                </a:ln>
                <a:solidFill>
                  <a:srgbClr val="1F1F1F"/>
                </a:solidFill>
                <a:effectLst/>
                <a:latin typeface="+mn-lt"/>
              </a:rPr>
              <a:t>8</a:t>
            </a:r>
            <a:r>
              <a:rPr kumimoji="0" lang="en-SA" altLang="en-SA" sz="1200" b="1" i="0" u="none" strike="noStrike" cap="none" normalizeH="0" baseline="0" dirty="0">
                <a:ln>
                  <a:noFill/>
                </a:ln>
                <a:solidFill>
                  <a:srgbClr val="1F1F1F"/>
                </a:solidFill>
                <a:effectLst/>
                <a:latin typeface="+mn-lt"/>
              </a:rPr>
              <a:t>]</a:t>
            </a:r>
            <a:r>
              <a:rPr kumimoji="0" lang="en-SA" altLang="en-SA" sz="1200" b="1" i="0" u="none" strike="noStrike" cap="none" normalizeH="0" baseline="30000" dirty="0">
                <a:ln>
                  <a:noFill/>
                </a:ln>
                <a:solidFill>
                  <a:srgbClr val="1F1F1F"/>
                </a:solidFill>
                <a:effectLst/>
                <a:latin typeface="+mn-lt"/>
              </a:rPr>
              <a:t>+</a:t>
            </a:r>
            <a:r>
              <a:rPr kumimoji="0" lang="en-SA" altLang="en-SA" sz="1200" b="1" i="0" u="none" strike="noStrike" cap="none" normalizeH="0" baseline="0" dirty="0">
                <a:ln>
                  <a:noFill/>
                </a:ln>
                <a:solidFill>
                  <a:srgbClr val="1F1F1F"/>
                </a:solidFill>
                <a:effectLst/>
                <a:latin typeface="+mn-lt"/>
              </a:rPr>
              <a:t>, 10.4), 304 ([M</a:t>
            </a:r>
            <a:r>
              <a:rPr kumimoji="0" lang="en-SA" altLang="en-SA" sz="1200" b="1" i="0" u="none" strike="noStrike" cap="none" normalizeH="0" baseline="30000" dirty="0">
                <a:ln>
                  <a:noFill/>
                </a:ln>
                <a:solidFill>
                  <a:srgbClr val="1F1F1F"/>
                </a:solidFill>
                <a:effectLst/>
                <a:latin typeface="+mn-lt"/>
              </a:rPr>
              <a:t>+</a:t>
            </a:r>
            <a:r>
              <a:rPr kumimoji="0" lang="en-SA" altLang="en-SA" sz="1200" b="1" i="0" u="none" strike="noStrike" cap="none" normalizeH="0" baseline="0" dirty="0">
                <a:ln>
                  <a:noFill/>
                </a:ln>
                <a:solidFill>
                  <a:srgbClr val="1F1F1F"/>
                </a:solidFill>
                <a:effectLst/>
                <a:latin typeface="+mn-lt"/>
              </a:rPr>
              <a:t>−97], [C</a:t>
            </a:r>
            <a:r>
              <a:rPr kumimoji="0" lang="en-SA" altLang="en-SA" sz="1200" b="1" i="0" u="none" strike="noStrike" cap="none" normalizeH="0" baseline="-30000" dirty="0">
                <a:ln>
                  <a:noFill/>
                </a:ln>
                <a:solidFill>
                  <a:srgbClr val="1F1F1F"/>
                </a:solidFill>
                <a:effectLst/>
                <a:latin typeface="+mn-lt"/>
              </a:rPr>
              <a:t>14</a:t>
            </a:r>
            <a:r>
              <a:rPr kumimoji="0" lang="en-SA" altLang="en-SA" sz="1200" b="1" i="0" u="none" strike="noStrike" cap="none" normalizeH="0" baseline="0" dirty="0">
                <a:ln>
                  <a:noFill/>
                </a:ln>
                <a:solidFill>
                  <a:srgbClr val="1F1F1F"/>
                </a:solidFill>
                <a:effectLst/>
                <a:latin typeface="+mn-lt"/>
              </a:rPr>
              <a:t>H</a:t>
            </a:r>
            <a:r>
              <a:rPr kumimoji="0" lang="en-SA" altLang="en-SA" sz="1200" b="1" i="0" u="none" strike="noStrike" cap="none" normalizeH="0" baseline="-30000" dirty="0">
                <a:ln>
                  <a:noFill/>
                </a:ln>
                <a:solidFill>
                  <a:srgbClr val="1F1F1F"/>
                </a:solidFill>
                <a:effectLst/>
                <a:latin typeface="+mn-lt"/>
              </a:rPr>
              <a:t>10</a:t>
            </a:r>
            <a:r>
              <a:rPr kumimoji="0" lang="en-SA" altLang="en-SA" sz="1200" b="1" i="0" u="none" strike="noStrike" cap="none" normalizeH="0" baseline="0" dirty="0">
                <a:ln>
                  <a:noFill/>
                </a:ln>
                <a:solidFill>
                  <a:srgbClr val="1F1F1F"/>
                </a:solidFill>
                <a:effectLst/>
                <a:latin typeface="+mn-lt"/>
              </a:rPr>
              <a:t>NO</a:t>
            </a:r>
            <a:r>
              <a:rPr kumimoji="0" lang="en-SA" altLang="en-SA" sz="1200" b="1" i="0" u="none" strike="noStrike" cap="none" normalizeH="0" baseline="-30000" dirty="0">
                <a:ln>
                  <a:noFill/>
                </a:ln>
                <a:solidFill>
                  <a:srgbClr val="1F1F1F"/>
                </a:solidFill>
                <a:effectLst/>
                <a:latin typeface="+mn-lt"/>
              </a:rPr>
              <a:t>7</a:t>
            </a:r>
            <a:r>
              <a:rPr kumimoji="0" lang="en-SA" altLang="en-SA" sz="1200" b="1" i="0" u="none" strike="noStrike" cap="none" normalizeH="0" baseline="0" dirty="0">
                <a:ln>
                  <a:noFill/>
                </a:ln>
                <a:solidFill>
                  <a:srgbClr val="1F1F1F"/>
                </a:solidFill>
                <a:effectLst/>
                <a:latin typeface="+mn-lt"/>
              </a:rPr>
              <a:t>]</a:t>
            </a:r>
            <a:r>
              <a:rPr kumimoji="0" lang="en-SA" altLang="en-SA" sz="1200" b="1" i="0" u="none" strike="noStrike" cap="none" normalizeH="0" baseline="30000" dirty="0">
                <a:ln>
                  <a:noFill/>
                </a:ln>
                <a:solidFill>
                  <a:srgbClr val="1F1F1F"/>
                </a:solidFill>
                <a:effectLst/>
                <a:latin typeface="+mn-lt"/>
              </a:rPr>
              <a:t>+</a:t>
            </a:r>
            <a:r>
              <a:rPr kumimoji="0" lang="en-SA" altLang="en-SA" sz="1200" b="1" i="0" u="none" strike="noStrike" cap="none" normalizeH="0" baseline="0" dirty="0">
                <a:ln>
                  <a:noFill/>
                </a:ln>
                <a:solidFill>
                  <a:srgbClr val="1F1F1F"/>
                </a:solidFill>
                <a:effectLst/>
                <a:latin typeface="+mn-lt"/>
              </a:rPr>
              <a:t>, 100), 97 ([M</a:t>
            </a:r>
            <a:r>
              <a:rPr kumimoji="0" lang="en-SA" altLang="en-SA" sz="1200" b="1" i="0" u="none" strike="noStrike" cap="none" normalizeH="0" baseline="30000" dirty="0">
                <a:ln>
                  <a:noFill/>
                </a:ln>
                <a:solidFill>
                  <a:srgbClr val="1F1F1F"/>
                </a:solidFill>
                <a:effectLst/>
                <a:latin typeface="+mn-lt"/>
              </a:rPr>
              <a:t>+</a:t>
            </a:r>
            <a:r>
              <a:rPr kumimoji="0" lang="en-SA" altLang="en-SA" sz="1200" b="1" i="0" u="none" strike="noStrike" cap="none" normalizeH="0" baseline="0" dirty="0">
                <a:ln>
                  <a:noFill/>
                </a:ln>
                <a:solidFill>
                  <a:srgbClr val="1F1F1F"/>
                </a:solidFill>
                <a:effectLst/>
                <a:latin typeface="+mn-lt"/>
              </a:rPr>
              <a:t>−304], [C</a:t>
            </a:r>
            <a:r>
              <a:rPr kumimoji="0" lang="en-SA" altLang="en-SA" sz="1200" b="1" i="0" u="none" strike="noStrike" cap="none" normalizeH="0" baseline="-30000" dirty="0">
                <a:ln>
                  <a:noFill/>
                </a:ln>
                <a:solidFill>
                  <a:srgbClr val="1F1F1F"/>
                </a:solidFill>
                <a:effectLst/>
                <a:latin typeface="+mn-lt"/>
              </a:rPr>
              <a:t>5</a:t>
            </a:r>
            <a:r>
              <a:rPr kumimoji="0" lang="en-SA" altLang="en-SA" sz="1200" b="1" i="0" u="none" strike="noStrike" cap="none" normalizeH="0" baseline="0" dirty="0">
                <a:ln>
                  <a:noFill/>
                </a:ln>
                <a:solidFill>
                  <a:srgbClr val="1F1F1F"/>
                </a:solidFill>
                <a:effectLst/>
                <a:latin typeface="+mn-lt"/>
              </a:rPr>
              <a:t>H</a:t>
            </a:r>
            <a:r>
              <a:rPr kumimoji="0" lang="en-SA" altLang="en-SA" sz="1200" b="1" i="0" u="none" strike="noStrike" cap="none" normalizeH="0" baseline="-30000" dirty="0">
                <a:ln>
                  <a:noFill/>
                </a:ln>
                <a:solidFill>
                  <a:srgbClr val="1F1F1F"/>
                </a:solidFill>
                <a:effectLst/>
                <a:latin typeface="+mn-lt"/>
              </a:rPr>
              <a:t>5</a:t>
            </a:r>
            <a:r>
              <a:rPr kumimoji="0" lang="en-SA" altLang="en-SA" sz="1200" b="1" i="0" u="none" strike="noStrike" cap="none" normalizeH="0" baseline="0" dirty="0">
                <a:ln>
                  <a:noFill/>
                </a:ln>
                <a:solidFill>
                  <a:srgbClr val="1F1F1F"/>
                </a:solidFill>
                <a:effectLst/>
                <a:latin typeface="+mn-lt"/>
              </a:rPr>
              <a:t>O</a:t>
            </a:r>
            <a:r>
              <a:rPr kumimoji="0" lang="en-SA" altLang="en-SA" sz="1200" b="1" i="0" u="none" strike="noStrike" cap="none" normalizeH="0" baseline="-30000" dirty="0">
                <a:ln>
                  <a:noFill/>
                </a:ln>
                <a:solidFill>
                  <a:srgbClr val="1F1F1F"/>
                </a:solidFill>
                <a:effectLst/>
                <a:latin typeface="+mn-lt"/>
              </a:rPr>
              <a:t>2</a:t>
            </a:r>
            <a:r>
              <a:rPr kumimoji="0" lang="en-SA" altLang="en-SA" sz="1200" b="1" i="0" u="none" strike="noStrike" cap="none" normalizeH="0" baseline="0" dirty="0">
                <a:ln>
                  <a:noFill/>
                </a:ln>
                <a:solidFill>
                  <a:srgbClr val="1F1F1F"/>
                </a:solidFill>
                <a:effectLst/>
                <a:latin typeface="+mn-lt"/>
              </a:rPr>
              <a:t>]</a:t>
            </a:r>
            <a:r>
              <a:rPr kumimoji="0" lang="en-SA" altLang="en-SA" sz="1200" b="1" i="0" u="none" strike="noStrike" cap="none" normalizeH="0" baseline="30000" dirty="0">
                <a:ln>
                  <a:noFill/>
                </a:ln>
                <a:solidFill>
                  <a:srgbClr val="1F1F1F"/>
                </a:solidFill>
                <a:effectLst/>
                <a:latin typeface="+mn-lt"/>
              </a:rPr>
              <a:t>+</a:t>
            </a:r>
            <a:r>
              <a:rPr kumimoji="0" lang="en-SA" altLang="en-SA" sz="1200" b="1" i="0" u="none" strike="noStrike" cap="none" normalizeH="0" baseline="0" dirty="0">
                <a:ln>
                  <a:noFill/>
                </a:ln>
                <a:solidFill>
                  <a:srgbClr val="1F1F1F"/>
                </a:solidFill>
                <a:effectLst/>
                <a:latin typeface="+mn-lt"/>
              </a:rPr>
              <a:t>, 82.3); HRMS/EI: </a:t>
            </a:r>
            <a:r>
              <a:rPr kumimoji="0" lang="en-SA" altLang="en-SA" sz="1200" b="1" i="1" u="none" strike="noStrike" cap="none" normalizeH="0" baseline="0" dirty="0">
                <a:ln>
                  <a:noFill/>
                </a:ln>
                <a:solidFill>
                  <a:srgbClr val="1F1F1F"/>
                </a:solidFill>
                <a:effectLst/>
                <a:latin typeface="+mn-lt"/>
              </a:rPr>
              <a:t>m</a:t>
            </a:r>
            <a:r>
              <a:rPr kumimoji="0" lang="en-SA" altLang="en-SA" sz="1200" b="1" i="0" u="none" strike="noStrike" cap="none" normalizeH="0" baseline="0" dirty="0">
                <a:ln>
                  <a:noFill/>
                </a:ln>
                <a:solidFill>
                  <a:srgbClr val="1F1F1F"/>
                </a:solidFill>
                <a:effectLst/>
                <a:latin typeface="+mn-lt"/>
              </a:rPr>
              <a:t>/</a:t>
            </a:r>
            <a:r>
              <a:rPr kumimoji="0" lang="en-SA" altLang="en-SA" sz="1200" b="1" i="1" u="none" strike="noStrike" cap="none" normalizeH="0" baseline="0" dirty="0">
                <a:ln>
                  <a:noFill/>
                </a:ln>
                <a:solidFill>
                  <a:srgbClr val="1F1F1F"/>
                </a:solidFill>
                <a:effectLst/>
                <a:latin typeface="+mn-lt"/>
              </a:rPr>
              <a:t>z</a:t>
            </a:r>
            <a:r>
              <a:rPr kumimoji="0" lang="en-SA" altLang="en-SA" sz="1200" b="1" i="0" u="none" strike="noStrike" cap="none" normalizeH="0" baseline="0" dirty="0">
                <a:ln>
                  <a:noFill/>
                </a:ln>
                <a:solidFill>
                  <a:srgbClr val="1F1F1F"/>
                </a:solidFill>
                <a:effectLst/>
                <a:latin typeface="+mn-lt"/>
              </a:rPr>
              <a:t> calcd for C</a:t>
            </a:r>
            <a:r>
              <a:rPr kumimoji="0" lang="en-SA" altLang="en-SA" sz="1200" b="1" i="0" u="none" strike="noStrike" cap="none" normalizeH="0" baseline="-30000" dirty="0">
                <a:ln>
                  <a:noFill/>
                </a:ln>
                <a:solidFill>
                  <a:srgbClr val="1F1F1F"/>
                </a:solidFill>
                <a:effectLst/>
                <a:latin typeface="+mn-lt"/>
              </a:rPr>
              <a:t>19</a:t>
            </a:r>
            <a:r>
              <a:rPr kumimoji="0" lang="en-SA" altLang="en-SA" sz="1200" b="1" i="0" u="none" strike="noStrike" cap="none" normalizeH="0" baseline="0" dirty="0">
                <a:ln>
                  <a:noFill/>
                </a:ln>
                <a:solidFill>
                  <a:srgbClr val="1F1F1F"/>
                </a:solidFill>
                <a:effectLst/>
                <a:latin typeface="+mn-lt"/>
              </a:rPr>
              <a:t>H</a:t>
            </a:r>
            <a:r>
              <a:rPr kumimoji="0" lang="en-SA" altLang="en-SA" sz="1200" b="1" i="0" u="none" strike="noStrike" cap="none" normalizeH="0" baseline="-30000" dirty="0">
                <a:ln>
                  <a:noFill/>
                </a:ln>
                <a:solidFill>
                  <a:srgbClr val="1F1F1F"/>
                </a:solidFill>
                <a:effectLst/>
                <a:latin typeface="+mn-lt"/>
              </a:rPr>
              <a:t>15</a:t>
            </a:r>
            <a:r>
              <a:rPr kumimoji="0" lang="en-SA" altLang="en-SA" sz="1200" b="1" i="0" u="none" strike="noStrike" cap="none" normalizeH="0" baseline="0" dirty="0">
                <a:ln>
                  <a:noFill/>
                </a:ln>
                <a:solidFill>
                  <a:srgbClr val="1F1F1F"/>
                </a:solidFill>
                <a:effectLst/>
                <a:latin typeface="+mn-lt"/>
              </a:rPr>
              <a:t>NO</a:t>
            </a:r>
            <a:r>
              <a:rPr kumimoji="0" lang="en-SA" altLang="en-SA" sz="1200" b="1" i="0" u="none" strike="noStrike" cap="none" normalizeH="0" baseline="-30000" dirty="0">
                <a:ln>
                  <a:noFill/>
                </a:ln>
                <a:solidFill>
                  <a:srgbClr val="1F1F1F"/>
                </a:solidFill>
                <a:effectLst/>
                <a:latin typeface="+mn-lt"/>
              </a:rPr>
              <a:t>9</a:t>
            </a:r>
            <a:r>
              <a:rPr kumimoji="0" lang="en-SA" altLang="en-SA" sz="1200" b="1" i="0" u="none" strike="noStrike" cap="none" normalizeH="0" baseline="0" dirty="0">
                <a:ln>
                  <a:noFill/>
                </a:ln>
                <a:solidFill>
                  <a:srgbClr val="1F1F1F"/>
                </a:solidFill>
                <a:effectLst/>
                <a:latin typeface="+mn-lt"/>
              </a:rPr>
              <a:t>: 401.0746. Found: 401.0745.</a:t>
            </a:r>
            <a:endParaRPr kumimoji="0" lang="en-SA" altLang="en-SA" sz="12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6A1A45F6-23F8-AA06-7A63-72E484E7F0AF}"/>
              </a:ext>
            </a:extLst>
          </p:cNvPr>
          <p:cNvSpPr txBox="1"/>
          <p:nvPr/>
        </p:nvSpPr>
        <p:spPr>
          <a:xfrm>
            <a:off x="7214124" y="3830528"/>
            <a:ext cx="3075201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SA" sz="1200" b="1" dirty="0"/>
              <a:t>NMR information adapted from:</a:t>
            </a:r>
          </a:p>
          <a:p>
            <a:r>
              <a:rPr lang="en-SA" sz="1200" b="1" dirty="0"/>
              <a:t>Zwanenburg et al., 2011</a:t>
            </a:r>
          </a:p>
          <a:p>
            <a:r>
              <a:rPr lang="en-SA" sz="1200" b="1" dirty="0"/>
              <a:t>(</a:t>
            </a:r>
            <a:r>
              <a:rPr lang="en-US" sz="1200" b="1" i="0" u="none" strike="noStrike" dirty="0">
                <a:effectLst/>
                <a:hlinkClick r:id="rId3" tooltip="Persistent link using digital object identifier"/>
              </a:rPr>
              <a:t>https://doi.org/10.1016/j.bmc.2011.10.057</a:t>
            </a:r>
            <a:r>
              <a:rPr lang="en-SA" sz="1200" b="1" i="0" u="none" strike="noStrike" dirty="0">
                <a:effectLst/>
              </a:rPr>
              <a:t>)</a:t>
            </a:r>
            <a:endParaRPr lang="en-SA" sz="1200" b="1" dirty="0"/>
          </a:p>
        </p:txBody>
      </p:sp>
      <p:pic>
        <p:nvPicPr>
          <p:cNvPr id="9" name="Picture 8">
            <a:extLst>
              <a:ext uri="{FF2B5EF4-FFF2-40B4-BE49-F238E27FC236}">
                <a16:creationId xmlns:a16="http://schemas.microsoft.com/office/drawing/2014/main" id="{CB07727F-E4F7-B4E6-3971-CDC32C2B0EEA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5907" t="4346" r="8799" b="8323"/>
          <a:stretch/>
        </p:blipFill>
        <p:spPr>
          <a:xfrm>
            <a:off x="67769" y="465159"/>
            <a:ext cx="7147585" cy="517765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1496312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A7CBE10D-EAFB-AE07-168B-5C931D4076F5}"/>
              </a:ext>
            </a:extLst>
          </p:cNvPr>
          <p:cNvSpPr txBox="1"/>
          <p:nvPr/>
        </p:nvSpPr>
        <p:spPr>
          <a:xfrm>
            <a:off x="1575004" y="5442718"/>
            <a:ext cx="948528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SA" sz="14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3: </a:t>
            </a: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Effect of MP3 and Nijmegen-1 on optical density and cell viability of various strains. </a:t>
            </a:r>
            <a:endParaRPr lang="en-SA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88F76D17-BF22-1C6F-74B1-D9E76145BBA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15882" y="712337"/>
            <a:ext cx="5280117" cy="4190271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4A9F77A2-4805-8EA5-754D-1F15731A0333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444662" y="712337"/>
            <a:ext cx="4836160" cy="416052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20339081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AC7CC0E5-B5C6-CE90-4EF8-597BA4F6E437}"/>
              </a:ext>
            </a:extLst>
          </p:cNvPr>
          <p:cNvSpPr txBox="1"/>
          <p:nvPr/>
        </p:nvSpPr>
        <p:spPr>
          <a:xfrm>
            <a:off x="1744531" y="757059"/>
            <a:ext cx="7346538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400" b="1" kern="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upplementary Table 1: Positive Controls used in the Absence of the Metabolic Activation System</a:t>
            </a:r>
            <a:endParaRPr lang="en-SA" sz="14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7" name="Table 6">
            <a:extLst>
              <a:ext uri="{FF2B5EF4-FFF2-40B4-BE49-F238E27FC236}">
                <a16:creationId xmlns:a16="http://schemas.microsoft.com/office/drawing/2014/main" id="{6376BD6A-F6C0-970F-D221-CEDF9D222DB2}"/>
              </a:ext>
            </a:extLst>
          </p:cNvPr>
          <p:cNvGraphicFramePr>
            <a:graphicFrameLocks noGrp="1"/>
          </p:cNvGraphicFramePr>
          <p:nvPr/>
        </p:nvGraphicFramePr>
        <p:xfrm>
          <a:off x="722555" y="1234440"/>
          <a:ext cx="10445676" cy="2194560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1740946">
                  <a:extLst>
                    <a:ext uri="{9D8B030D-6E8A-4147-A177-3AD203B41FA5}">
                      <a16:colId xmlns:a16="http://schemas.microsoft.com/office/drawing/2014/main" val="1660060690"/>
                    </a:ext>
                  </a:extLst>
                </a:gridCol>
                <a:gridCol w="1740946">
                  <a:extLst>
                    <a:ext uri="{9D8B030D-6E8A-4147-A177-3AD203B41FA5}">
                      <a16:colId xmlns:a16="http://schemas.microsoft.com/office/drawing/2014/main" val="2453708193"/>
                    </a:ext>
                  </a:extLst>
                </a:gridCol>
                <a:gridCol w="1740946">
                  <a:extLst>
                    <a:ext uri="{9D8B030D-6E8A-4147-A177-3AD203B41FA5}">
                      <a16:colId xmlns:a16="http://schemas.microsoft.com/office/drawing/2014/main" val="2516163927"/>
                    </a:ext>
                  </a:extLst>
                </a:gridCol>
                <a:gridCol w="1740946">
                  <a:extLst>
                    <a:ext uri="{9D8B030D-6E8A-4147-A177-3AD203B41FA5}">
                      <a16:colId xmlns:a16="http://schemas.microsoft.com/office/drawing/2014/main" val="1462005398"/>
                    </a:ext>
                  </a:extLst>
                </a:gridCol>
                <a:gridCol w="1740946">
                  <a:extLst>
                    <a:ext uri="{9D8B030D-6E8A-4147-A177-3AD203B41FA5}">
                      <a16:colId xmlns:a16="http://schemas.microsoft.com/office/drawing/2014/main" val="193445231"/>
                    </a:ext>
                  </a:extLst>
                </a:gridCol>
                <a:gridCol w="1740946">
                  <a:extLst>
                    <a:ext uri="{9D8B030D-6E8A-4147-A177-3AD203B41FA5}">
                      <a16:colId xmlns:a16="http://schemas.microsoft.com/office/drawing/2014/main" val="500667496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r>
                        <a:rPr lang="en-SA" sz="1200" kern="100">
                          <a:effectLst/>
                        </a:rPr>
                        <a:t> </a:t>
                      </a:r>
                      <a:endParaRPr lang="en-SA" sz="12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SA" sz="1200" kern="100">
                          <a:effectLst/>
                        </a:rPr>
                        <a:t>TA1537</a:t>
                      </a:r>
                      <a:endParaRPr lang="en-SA" sz="12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SA" sz="1200" kern="100">
                          <a:effectLst/>
                        </a:rPr>
                        <a:t>TA1535</a:t>
                      </a:r>
                      <a:endParaRPr lang="en-SA" sz="12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SA" sz="1200" kern="100">
                          <a:effectLst/>
                        </a:rPr>
                        <a:t>TA100</a:t>
                      </a:r>
                      <a:endParaRPr lang="en-SA" sz="12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SA" sz="1200" kern="100">
                          <a:effectLst/>
                        </a:rPr>
                        <a:t>TA98</a:t>
                      </a:r>
                      <a:endParaRPr lang="en-SA" sz="12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SA" sz="1200" kern="100">
                          <a:effectLst/>
                        </a:rPr>
                        <a:t>TA102</a:t>
                      </a:r>
                      <a:endParaRPr lang="en-SA" sz="12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453779836"/>
                  </a:ext>
                </a:extLst>
              </a:tr>
              <a:tr h="0">
                <a:tc>
                  <a:txBody>
                    <a:bodyPr/>
                    <a:lstStyle/>
                    <a:p>
                      <a:r>
                        <a:rPr lang="en-SA" sz="1200" kern="100">
                          <a:effectLst/>
                        </a:rPr>
                        <a:t>Name of Positive Control</a:t>
                      </a:r>
                      <a:endParaRPr lang="en-SA" sz="12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SA" sz="1200" kern="100">
                          <a:effectLst/>
                        </a:rPr>
                        <a:t>9-Aminoacridine hydrochloride monohydrate</a:t>
                      </a:r>
                      <a:endParaRPr lang="en-SA" sz="12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SA" sz="1200" kern="100">
                          <a:effectLst/>
                        </a:rPr>
                        <a:t>Sodium azide</a:t>
                      </a:r>
                      <a:endParaRPr lang="en-SA" sz="12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SA" sz="1200" kern="100">
                          <a:effectLst/>
                        </a:rPr>
                        <a:t>Sodium azide</a:t>
                      </a:r>
                      <a:endParaRPr lang="en-SA" sz="12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SA" sz="1200" kern="100">
                          <a:effectLst/>
                        </a:rPr>
                        <a:t>2- Nitrofluorene</a:t>
                      </a:r>
                      <a:endParaRPr lang="en-SA" sz="12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SA" sz="1200" kern="100">
                          <a:effectLst/>
                        </a:rPr>
                        <a:t>Mitomycin C</a:t>
                      </a:r>
                      <a:endParaRPr lang="en-SA" sz="12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269748584"/>
                  </a:ext>
                </a:extLst>
              </a:tr>
              <a:tr h="0">
                <a:tc>
                  <a:txBody>
                    <a:bodyPr/>
                    <a:lstStyle/>
                    <a:p>
                      <a:r>
                        <a:rPr lang="en-SA" sz="1200" kern="100">
                          <a:effectLst/>
                        </a:rPr>
                        <a:t>Manufactured by</a:t>
                      </a:r>
                      <a:endParaRPr lang="en-SA" sz="12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SA" sz="1200" kern="100">
                          <a:effectLst/>
                        </a:rPr>
                        <a:t>Aldrich</a:t>
                      </a:r>
                      <a:endParaRPr lang="en-SA" sz="12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SA" sz="1200" kern="100">
                          <a:effectLst/>
                        </a:rPr>
                        <a:t>SIAL</a:t>
                      </a:r>
                      <a:endParaRPr lang="en-SA" sz="12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SA" sz="1200" kern="100">
                          <a:effectLst/>
                        </a:rPr>
                        <a:t>SIAL</a:t>
                      </a:r>
                      <a:endParaRPr lang="en-SA" sz="12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SA" sz="1200" kern="100">
                          <a:effectLst/>
                        </a:rPr>
                        <a:t>Aldrich</a:t>
                      </a:r>
                      <a:endParaRPr lang="en-SA" sz="12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SA" sz="1200" kern="100">
                          <a:effectLst/>
                        </a:rPr>
                        <a:t>Sigma</a:t>
                      </a:r>
                      <a:endParaRPr lang="en-SA" sz="12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614050018"/>
                  </a:ext>
                </a:extLst>
              </a:tr>
              <a:tr h="0">
                <a:tc>
                  <a:txBody>
                    <a:bodyPr/>
                    <a:lstStyle/>
                    <a:p>
                      <a:r>
                        <a:rPr lang="en-SA" sz="1200" kern="100">
                          <a:effectLst/>
                        </a:rPr>
                        <a:t>Lot N°</a:t>
                      </a:r>
                      <a:endParaRPr lang="en-SA" sz="12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SA" sz="1200" kern="100">
                          <a:effectLst/>
                        </a:rPr>
                        <a:t>BCCD1970</a:t>
                      </a:r>
                      <a:endParaRPr lang="en-SA" sz="12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SA" sz="1200" kern="100">
                          <a:effectLst/>
                        </a:rPr>
                        <a:t>MKCB6155</a:t>
                      </a:r>
                      <a:endParaRPr lang="en-SA" sz="12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SA" sz="1200" kern="100">
                          <a:effectLst/>
                        </a:rPr>
                        <a:t>MKCB6155</a:t>
                      </a:r>
                      <a:endParaRPr lang="en-SA" sz="12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SA" sz="1200" kern="100">
                          <a:effectLst/>
                        </a:rPr>
                        <a:t>STBF2425V</a:t>
                      </a:r>
                      <a:endParaRPr lang="en-SA" sz="12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SA" sz="1200" kern="100">
                          <a:effectLst/>
                        </a:rPr>
                        <a:t>SLCB4710</a:t>
                      </a:r>
                      <a:endParaRPr lang="en-SA" sz="12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665144556"/>
                  </a:ext>
                </a:extLst>
              </a:tr>
              <a:tr h="0">
                <a:tc>
                  <a:txBody>
                    <a:bodyPr/>
                    <a:lstStyle/>
                    <a:p>
                      <a:r>
                        <a:rPr lang="en-SA" sz="1200" kern="100">
                          <a:effectLst/>
                        </a:rPr>
                        <a:t>CAS Number</a:t>
                      </a:r>
                      <a:endParaRPr lang="en-SA" sz="12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SA" sz="1200" kern="100">
                          <a:effectLst/>
                        </a:rPr>
                        <a:t>52417-22-8</a:t>
                      </a:r>
                      <a:endParaRPr lang="en-SA" sz="12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SA" sz="1200" kern="100">
                          <a:effectLst/>
                        </a:rPr>
                        <a:t>26628-22-8</a:t>
                      </a:r>
                      <a:endParaRPr lang="en-SA" sz="12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SA" sz="1200" kern="100">
                          <a:effectLst/>
                        </a:rPr>
                        <a:t>26628-22-8</a:t>
                      </a:r>
                      <a:endParaRPr lang="en-SA" sz="12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SA" sz="1200" kern="100">
                          <a:effectLst/>
                        </a:rPr>
                        <a:t>607-57-8</a:t>
                      </a:r>
                      <a:endParaRPr lang="en-SA" sz="12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SA" sz="1200" kern="100">
                          <a:effectLst/>
                        </a:rPr>
                        <a:t>50-07-7</a:t>
                      </a:r>
                      <a:endParaRPr lang="en-SA" sz="12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816383757"/>
                  </a:ext>
                </a:extLst>
              </a:tr>
              <a:tr h="0">
                <a:tc>
                  <a:txBody>
                    <a:bodyPr/>
                    <a:lstStyle/>
                    <a:p>
                      <a:r>
                        <a:rPr lang="en-SA" sz="1200" kern="100">
                          <a:effectLst/>
                        </a:rPr>
                        <a:t>Purity</a:t>
                      </a:r>
                      <a:endParaRPr lang="en-SA" sz="12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SA" sz="1200" kern="100">
                          <a:effectLst/>
                        </a:rPr>
                        <a:t>98.8%</a:t>
                      </a:r>
                      <a:endParaRPr lang="en-SA" sz="12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SA" sz="1200" kern="100">
                          <a:effectLst/>
                        </a:rPr>
                        <a:t>99.6%</a:t>
                      </a:r>
                      <a:endParaRPr lang="en-SA" sz="12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SA" sz="1200" kern="100">
                          <a:effectLst/>
                        </a:rPr>
                        <a:t>99.6%</a:t>
                      </a:r>
                      <a:endParaRPr lang="en-SA" sz="12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SA" sz="1200" kern="100" dirty="0">
                          <a:effectLst/>
                        </a:rPr>
                        <a:t>99.9%</a:t>
                      </a:r>
                      <a:endParaRPr lang="en-SA" sz="12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SA" sz="1200" kern="100">
                          <a:effectLst/>
                        </a:rPr>
                        <a:t>vial contains 2 mg of Mitomycin C</a:t>
                      </a:r>
                      <a:endParaRPr lang="en-SA" sz="12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499456467"/>
                  </a:ext>
                </a:extLst>
              </a:tr>
              <a:tr h="0">
                <a:tc>
                  <a:txBody>
                    <a:bodyPr/>
                    <a:lstStyle/>
                    <a:p>
                      <a:r>
                        <a:rPr lang="en-SA" sz="1200" kern="100">
                          <a:effectLst/>
                        </a:rPr>
                        <a:t>Appearance</a:t>
                      </a:r>
                      <a:endParaRPr lang="en-SA" sz="12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SA" sz="1200" kern="100">
                          <a:effectLst/>
                        </a:rPr>
                        <a:t>Yellow powder</a:t>
                      </a:r>
                      <a:endParaRPr lang="en-SA" sz="12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SA" sz="1200" kern="100">
                          <a:effectLst/>
                        </a:rPr>
                        <a:t>White powder</a:t>
                      </a:r>
                      <a:endParaRPr lang="en-SA" sz="12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SA" sz="1200" kern="100">
                          <a:effectLst/>
                        </a:rPr>
                        <a:t>White powder</a:t>
                      </a:r>
                      <a:endParaRPr lang="en-SA" sz="12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SA" sz="1200" kern="100">
                          <a:effectLst/>
                        </a:rPr>
                        <a:t>Yellow Powder</a:t>
                      </a:r>
                      <a:endParaRPr lang="en-SA" sz="12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SA" sz="1200" kern="100">
                          <a:effectLst/>
                        </a:rPr>
                        <a:t>Light Grey-Blue Powder</a:t>
                      </a:r>
                      <a:endParaRPr lang="en-SA" sz="12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670319644"/>
                  </a:ext>
                </a:extLst>
              </a:tr>
              <a:tr h="0">
                <a:tc>
                  <a:txBody>
                    <a:bodyPr/>
                    <a:lstStyle/>
                    <a:p>
                      <a:r>
                        <a:rPr lang="en-SA" sz="1200" kern="100">
                          <a:effectLst/>
                        </a:rPr>
                        <a:t>Storage</a:t>
                      </a:r>
                      <a:endParaRPr lang="en-SA" sz="12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SA" sz="1200" kern="100">
                          <a:effectLst/>
                        </a:rPr>
                        <a:t>Room temperature</a:t>
                      </a:r>
                      <a:endParaRPr lang="en-SA" sz="12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SA" sz="1200" kern="100">
                          <a:effectLst/>
                        </a:rPr>
                        <a:t>Room temperature</a:t>
                      </a:r>
                      <a:endParaRPr lang="en-SA" sz="12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SA" sz="1200" kern="100">
                          <a:effectLst/>
                        </a:rPr>
                        <a:t>Room temperature</a:t>
                      </a:r>
                      <a:endParaRPr lang="en-SA" sz="12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SA" sz="1200" kern="100">
                          <a:effectLst/>
                        </a:rPr>
                        <a:t>Room temperature</a:t>
                      </a:r>
                      <a:endParaRPr lang="en-SA" sz="12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SA" sz="1200" kern="100">
                          <a:effectLst/>
                        </a:rPr>
                        <a:t>2 - 8 °C</a:t>
                      </a:r>
                      <a:endParaRPr lang="en-SA" sz="12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589436828"/>
                  </a:ext>
                </a:extLst>
              </a:tr>
              <a:tr h="0">
                <a:tc>
                  <a:txBody>
                    <a:bodyPr/>
                    <a:lstStyle/>
                    <a:p>
                      <a:r>
                        <a:rPr lang="en-SA" sz="1200" kern="100">
                          <a:effectLst/>
                        </a:rPr>
                        <a:t>Concentration</a:t>
                      </a:r>
                      <a:endParaRPr lang="en-SA" sz="12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SA" sz="1200" kern="100" dirty="0">
                          <a:effectLst/>
                        </a:rPr>
                        <a:t>75.0 μg/plate</a:t>
                      </a:r>
                      <a:endParaRPr lang="en-SA" sz="12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SA" sz="1200" kern="100">
                          <a:effectLst/>
                        </a:rPr>
                        <a:t>0.5 μg/plate</a:t>
                      </a:r>
                      <a:endParaRPr lang="en-SA" sz="12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SA" sz="1200" kern="100">
                          <a:effectLst/>
                        </a:rPr>
                        <a:t>5.0 μg/plate</a:t>
                      </a:r>
                      <a:endParaRPr lang="en-SA" sz="12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SA" sz="1200" kern="100" dirty="0">
                          <a:effectLst/>
                        </a:rPr>
                        <a:t>7.5 μg/plate</a:t>
                      </a:r>
                      <a:endParaRPr lang="en-SA" sz="12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SA" sz="1200" kern="100" dirty="0">
                          <a:effectLst/>
                        </a:rPr>
                        <a:t>0.5 μg/plate</a:t>
                      </a:r>
                      <a:endParaRPr lang="en-SA" sz="12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19325027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5950807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37FCE151-9334-6BD6-8DC3-CCB1AD8FD5D2}"/>
              </a:ext>
            </a:extLst>
          </p:cNvPr>
          <p:cNvSpPr txBox="1"/>
          <p:nvPr/>
        </p:nvSpPr>
        <p:spPr>
          <a:xfrm>
            <a:off x="2405619" y="861781"/>
            <a:ext cx="7032931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400" b="1" kern="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upplementary Table 2: Positive Control used in the Presence of Metabolic Activation System</a:t>
            </a:r>
            <a:endParaRPr lang="en-SA" sz="14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8" name="Table 7">
            <a:extLst>
              <a:ext uri="{FF2B5EF4-FFF2-40B4-BE49-F238E27FC236}">
                <a16:creationId xmlns:a16="http://schemas.microsoft.com/office/drawing/2014/main" id="{8CAB8EAA-F4C6-0F7F-1242-46B3BB6043DF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41900277"/>
              </p:ext>
            </p:extLst>
          </p:nvPr>
        </p:nvGraphicFramePr>
        <p:xfrm>
          <a:off x="1366222" y="1316705"/>
          <a:ext cx="9111726" cy="2297862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3037242">
                  <a:extLst>
                    <a:ext uri="{9D8B030D-6E8A-4147-A177-3AD203B41FA5}">
                      <a16:colId xmlns:a16="http://schemas.microsoft.com/office/drawing/2014/main" val="3742729346"/>
                    </a:ext>
                  </a:extLst>
                </a:gridCol>
                <a:gridCol w="3037242">
                  <a:extLst>
                    <a:ext uri="{9D8B030D-6E8A-4147-A177-3AD203B41FA5}">
                      <a16:colId xmlns:a16="http://schemas.microsoft.com/office/drawing/2014/main" val="580868197"/>
                    </a:ext>
                  </a:extLst>
                </a:gridCol>
                <a:gridCol w="3037242">
                  <a:extLst>
                    <a:ext uri="{9D8B030D-6E8A-4147-A177-3AD203B41FA5}">
                      <a16:colId xmlns:a16="http://schemas.microsoft.com/office/drawing/2014/main" val="1243811515"/>
                    </a:ext>
                  </a:extLst>
                </a:gridCol>
              </a:tblGrid>
              <a:tr h="255318">
                <a:tc>
                  <a:txBody>
                    <a:bodyPr/>
                    <a:lstStyle/>
                    <a:p>
                      <a:r>
                        <a:rPr lang="en-SA" sz="1400" kern="100">
                          <a:effectLst/>
                        </a:rPr>
                        <a:t> </a:t>
                      </a:r>
                      <a:endParaRPr lang="en-SA" sz="14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SA" sz="1400" kern="100" dirty="0">
                          <a:effectLst/>
                        </a:rPr>
                        <a:t>TA1537/TA1535/TA102</a:t>
                      </a:r>
                      <a:endParaRPr lang="en-SA" sz="14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SA" sz="1400" kern="100" dirty="0">
                          <a:effectLst/>
                        </a:rPr>
                        <a:t>TA98/TA100</a:t>
                      </a:r>
                      <a:endParaRPr lang="en-SA" sz="14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959076483"/>
                  </a:ext>
                </a:extLst>
              </a:tr>
              <a:tr h="255318">
                <a:tc>
                  <a:txBody>
                    <a:bodyPr/>
                    <a:lstStyle/>
                    <a:p>
                      <a:r>
                        <a:rPr lang="en-SA" sz="1400" kern="100">
                          <a:effectLst/>
                        </a:rPr>
                        <a:t>Name of Positive Control</a:t>
                      </a:r>
                      <a:endParaRPr lang="en-SA" sz="14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SA" sz="1400" kern="100" dirty="0">
                          <a:effectLst/>
                        </a:rPr>
                        <a:t>2-Aminoanthracene</a:t>
                      </a:r>
                      <a:endParaRPr lang="en-SA" sz="14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SA" sz="1400" kern="100">
                          <a:effectLst/>
                        </a:rPr>
                        <a:t>2-Aminoanthracene</a:t>
                      </a:r>
                      <a:endParaRPr lang="en-SA" sz="14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525502031"/>
                  </a:ext>
                </a:extLst>
              </a:tr>
              <a:tr h="255318">
                <a:tc>
                  <a:txBody>
                    <a:bodyPr/>
                    <a:lstStyle/>
                    <a:p>
                      <a:r>
                        <a:rPr lang="en-SA" sz="1400" kern="100">
                          <a:effectLst/>
                        </a:rPr>
                        <a:t>Manufactured by</a:t>
                      </a:r>
                      <a:endParaRPr lang="en-SA" sz="14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SA" sz="1400" kern="100" dirty="0">
                          <a:effectLst/>
                        </a:rPr>
                        <a:t>Aldrich</a:t>
                      </a:r>
                      <a:endParaRPr lang="en-SA" sz="14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SA" sz="1400" kern="100">
                          <a:effectLst/>
                        </a:rPr>
                        <a:t>Aldrich</a:t>
                      </a:r>
                      <a:endParaRPr lang="en-SA" sz="14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241714657"/>
                  </a:ext>
                </a:extLst>
              </a:tr>
              <a:tr h="255318">
                <a:tc>
                  <a:txBody>
                    <a:bodyPr/>
                    <a:lstStyle/>
                    <a:p>
                      <a:r>
                        <a:rPr lang="en-SA" sz="1400" kern="100">
                          <a:effectLst/>
                        </a:rPr>
                        <a:t>Lot N°</a:t>
                      </a:r>
                      <a:endParaRPr lang="en-SA" sz="14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SA" sz="1400" kern="100" dirty="0">
                          <a:effectLst/>
                        </a:rPr>
                        <a:t>STBG0630V</a:t>
                      </a:r>
                      <a:endParaRPr lang="en-SA" sz="14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SA" sz="1400" kern="100" dirty="0">
                          <a:effectLst/>
                        </a:rPr>
                        <a:t>STBG0630V</a:t>
                      </a:r>
                      <a:endParaRPr lang="en-SA" sz="14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734180614"/>
                  </a:ext>
                </a:extLst>
              </a:tr>
              <a:tr h="255318">
                <a:tc>
                  <a:txBody>
                    <a:bodyPr/>
                    <a:lstStyle/>
                    <a:p>
                      <a:r>
                        <a:rPr lang="en-SA" sz="1400" kern="100">
                          <a:effectLst/>
                        </a:rPr>
                        <a:t>CAS Number</a:t>
                      </a:r>
                      <a:endParaRPr lang="en-SA" sz="14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SA" sz="1400" kern="100" dirty="0">
                          <a:effectLst/>
                        </a:rPr>
                        <a:t>613-13-8</a:t>
                      </a:r>
                      <a:endParaRPr lang="en-SA" sz="14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SA" sz="1400" kern="100">
                          <a:effectLst/>
                        </a:rPr>
                        <a:t>613-13-8</a:t>
                      </a:r>
                      <a:endParaRPr lang="en-SA" sz="14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700953666"/>
                  </a:ext>
                </a:extLst>
              </a:tr>
              <a:tr h="255318">
                <a:tc>
                  <a:txBody>
                    <a:bodyPr/>
                    <a:lstStyle/>
                    <a:p>
                      <a:r>
                        <a:rPr lang="en-SA" sz="1400" kern="100">
                          <a:effectLst/>
                        </a:rPr>
                        <a:t>Purity</a:t>
                      </a:r>
                      <a:endParaRPr lang="en-SA" sz="14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SA" sz="1400" kern="100" dirty="0">
                          <a:effectLst/>
                        </a:rPr>
                        <a:t>99.9%</a:t>
                      </a:r>
                      <a:endParaRPr lang="en-SA" sz="14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SA" sz="1400" kern="100">
                          <a:effectLst/>
                        </a:rPr>
                        <a:t>99.9%</a:t>
                      </a:r>
                      <a:endParaRPr lang="en-SA" sz="14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752130384"/>
                  </a:ext>
                </a:extLst>
              </a:tr>
              <a:tr h="255318">
                <a:tc>
                  <a:txBody>
                    <a:bodyPr/>
                    <a:lstStyle/>
                    <a:p>
                      <a:r>
                        <a:rPr lang="en-SA" sz="1400" kern="100" dirty="0">
                          <a:effectLst/>
                        </a:rPr>
                        <a:t>Appearance</a:t>
                      </a:r>
                      <a:endParaRPr lang="en-SA" sz="14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SA" sz="1400" kern="100" dirty="0">
                          <a:effectLst/>
                        </a:rPr>
                        <a:t>Olive green powder</a:t>
                      </a:r>
                      <a:endParaRPr lang="en-SA" sz="14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SA" sz="1400" kern="100">
                          <a:effectLst/>
                        </a:rPr>
                        <a:t>Olive green powder</a:t>
                      </a:r>
                      <a:endParaRPr lang="en-SA" sz="14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332746147"/>
                  </a:ext>
                </a:extLst>
              </a:tr>
              <a:tr h="255318">
                <a:tc>
                  <a:txBody>
                    <a:bodyPr/>
                    <a:lstStyle/>
                    <a:p>
                      <a:r>
                        <a:rPr lang="en-SA" sz="1400" kern="100">
                          <a:effectLst/>
                        </a:rPr>
                        <a:t>Storage</a:t>
                      </a:r>
                      <a:endParaRPr lang="en-SA" sz="14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SA" sz="1400" kern="100" dirty="0">
                          <a:effectLst/>
                        </a:rPr>
                        <a:t>Room temperature</a:t>
                      </a:r>
                      <a:endParaRPr lang="en-SA" sz="14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SA" sz="1400" kern="100">
                          <a:effectLst/>
                        </a:rPr>
                        <a:t>Room temperature</a:t>
                      </a:r>
                      <a:endParaRPr lang="en-SA" sz="14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376568201"/>
                  </a:ext>
                </a:extLst>
              </a:tr>
              <a:tr h="255318">
                <a:tc>
                  <a:txBody>
                    <a:bodyPr/>
                    <a:lstStyle/>
                    <a:p>
                      <a:r>
                        <a:rPr lang="en-SA" sz="1400" kern="100" dirty="0">
                          <a:effectLst/>
                        </a:rPr>
                        <a:t>Concentration</a:t>
                      </a:r>
                      <a:endParaRPr lang="en-SA" sz="14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SA" sz="1400" kern="100" dirty="0">
                          <a:effectLst/>
                        </a:rPr>
                        <a:t>10.0 μg/plate</a:t>
                      </a:r>
                      <a:endParaRPr lang="en-SA" sz="14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SA" sz="1400" kern="100" dirty="0">
                          <a:effectLst/>
                        </a:rPr>
                        <a:t>5.0 μg/plate</a:t>
                      </a:r>
                      <a:endParaRPr lang="en-SA" sz="14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52267077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86490192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A595051A-4761-AFB4-2F2F-6455D3441BF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677165" y="393010"/>
            <a:ext cx="5052060" cy="6250305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3D74F674-13B7-C5E7-03FD-DAB7C7F11587}"/>
              </a:ext>
            </a:extLst>
          </p:cNvPr>
          <p:cNvSpPr txBox="1"/>
          <p:nvPr/>
        </p:nvSpPr>
        <p:spPr>
          <a:xfrm>
            <a:off x="603606" y="0"/>
            <a:ext cx="10887750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1400" b="1" dirty="0"/>
              <a:t>Supplementary Table 3: Characteristic number of spontaneous revertants in response to MP3 and Nijmegen-1 (Historical control data)</a:t>
            </a:r>
            <a:endParaRPr lang="en-SA" sz="1400" b="1" dirty="0"/>
          </a:p>
        </p:txBody>
      </p:sp>
    </p:spTree>
    <p:extLst>
      <p:ext uri="{BB962C8B-B14F-4D97-AF65-F5344CB8AC3E}">
        <p14:creationId xmlns:p14="http://schemas.microsoft.com/office/powerpoint/2010/main" val="2181825948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Picture 7" descr="Table&#10;&#10;Description automatically generated">
            <a:extLst>
              <a:ext uri="{FF2B5EF4-FFF2-40B4-BE49-F238E27FC236}">
                <a16:creationId xmlns:a16="http://schemas.microsoft.com/office/drawing/2014/main" id="{24614BE4-BED4-D48C-EAE2-3CE84C88BE82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7958"/>
          <a:stretch/>
        </p:blipFill>
        <p:spPr>
          <a:xfrm>
            <a:off x="3856382" y="702369"/>
            <a:ext cx="4977517" cy="3557628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9429E3BF-A20B-51EB-12EB-8CEEC5FB054A}"/>
              </a:ext>
            </a:extLst>
          </p:cNvPr>
          <p:cNvSpPr txBox="1"/>
          <p:nvPr/>
        </p:nvSpPr>
        <p:spPr>
          <a:xfrm>
            <a:off x="3747604" y="252097"/>
            <a:ext cx="5086295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400" b="1" dirty="0"/>
              <a:t>Supplementary Table 4: Composition of Co-factor Mix and S9 Mix</a:t>
            </a:r>
            <a:endParaRPr lang="en-SA" sz="1400" b="1" dirty="0"/>
          </a:p>
        </p:txBody>
      </p:sp>
    </p:spTree>
    <p:extLst>
      <p:ext uri="{BB962C8B-B14F-4D97-AF65-F5344CB8AC3E}">
        <p14:creationId xmlns:p14="http://schemas.microsoft.com/office/powerpoint/2010/main" val="3587852461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Table&#10;&#10;Description automatically generated">
            <a:extLst>
              <a:ext uri="{FF2B5EF4-FFF2-40B4-BE49-F238E27FC236}">
                <a16:creationId xmlns:a16="http://schemas.microsoft.com/office/drawing/2014/main" id="{BB665167-CA33-1AFC-731D-B5996A9B6067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8483" b="13798"/>
          <a:stretch/>
        </p:blipFill>
        <p:spPr>
          <a:xfrm>
            <a:off x="2469280" y="1182806"/>
            <a:ext cx="6372346" cy="3268878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2E18CA44-581C-2DA6-49C8-4795E5F89B8C}"/>
              </a:ext>
            </a:extLst>
          </p:cNvPr>
          <p:cNvSpPr txBox="1"/>
          <p:nvPr/>
        </p:nvSpPr>
        <p:spPr>
          <a:xfrm>
            <a:off x="2351878" y="742682"/>
            <a:ext cx="6607150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Table 5: Composition of Top Agar and Minimal Glucose Agar</a:t>
            </a:r>
            <a:endParaRPr lang="en-SA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26572904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C11C4462-B77C-45B6-CA62-FCD928BF9501}"/>
              </a:ext>
            </a:extLst>
          </p:cNvPr>
          <p:cNvSpPr txBox="1"/>
          <p:nvPr/>
        </p:nvSpPr>
        <p:spPr>
          <a:xfrm>
            <a:off x="3443379" y="636702"/>
            <a:ext cx="3714098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400" b="1" dirty="0"/>
              <a:t>Supplementary Table 6: Efficiency Check Report</a:t>
            </a:r>
            <a:endParaRPr lang="en-SA" sz="1400" b="1" dirty="0"/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BDB8F6C4-DD49-B611-EA91-07C7BA5529D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893365" y="1096907"/>
            <a:ext cx="4973153" cy="376134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12971091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 2013 - 2022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344</TotalTime>
  <Words>928</Words>
  <Application>Microsoft Macintosh PowerPoint</Application>
  <PresentationFormat>Widescreen</PresentationFormat>
  <Paragraphs>162</Paragraphs>
  <Slides>1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1</vt:i4>
      </vt:variant>
    </vt:vector>
  </HeadingPairs>
  <TitlesOfParts>
    <vt:vector size="16" baseType="lpstr">
      <vt:lpstr>Arial</vt:lpstr>
      <vt:lpstr>Calibri</vt:lpstr>
      <vt:lpstr>Calibri Light</vt:lpstr>
      <vt:lpstr>Helvetica Neue</vt:lpstr>
      <vt:lpstr>Office Theme 2013 - 2022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uhammad Jamil</dc:creator>
  <cp:lastModifiedBy>Microsoft Office User</cp:lastModifiedBy>
  <cp:revision>24</cp:revision>
  <dcterms:created xsi:type="dcterms:W3CDTF">2022-12-30T18:00:51Z</dcterms:created>
  <dcterms:modified xsi:type="dcterms:W3CDTF">2024-09-28T13:56:01Z</dcterms:modified>
</cp:coreProperties>
</file>